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26"/>
  </p:notesMasterIdLst>
  <p:sldIdLst>
    <p:sldId id="274" r:id="rId2"/>
    <p:sldId id="275" r:id="rId3"/>
    <p:sldId id="278" r:id="rId4"/>
    <p:sldId id="257" r:id="rId5"/>
    <p:sldId id="281" r:id="rId6"/>
    <p:sldId id="258" r:id="rId7"/>
    <p:sldId id="260" r:id="rId8"/>
    <p:sldId id="280" r:id="rId9"/>
    <p:sldId id="279" r:id="rId10"/>
    <p:sldId id="283" r:id="rId11"/>
    <p:sldId id="282" r:id="rId12"/>
    <p:sldId id="262" r:id="rId13"/>
    <p:sldId id="287" r:id="rId14"/>
    <p:sldId id="284" r:id="rId15"/>
    <p:sldId id="267" r:id="rId16"/>
    <p:sldId id="286" r:id="rId17"/>
    <p:sldId id="266" r:id="rId18"/>
    <p:sldId id="270" r:id="rId19"/>
    <p:sldId id="289" r:id="rId20"/>
    <p:sldId id="291" r:id="rId21"/>
    <p:sldId id="273" r:id="rId22"/>
    <p:sldId id="288" r:id="rId23"/>
    <p:sldId id="290" r:id="rId24"/>
    <p:sldId id="269" r:id="rId2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E00DE"/>
    <a:srgbClr val="00BC55"/>
    <a:srgbClr val="0EB5CC"/>
    <a:srgbClr val="0FC3DB"/>
    <a:srgbClr val="00D661"/>
    <a:srgbClr val="BAD016"/>
    <a:srgbClr val="D5EA3A"/>
    <a:srgbClr val="FF00FF"/>
    <a:srgbClr val="24D8F0"/>
    <a:srgbClr val="15C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921" autoAdjust="0"/>
    <p:restoredTop sz="81959" autoAdjust="0"/>
  </p:normalViewPr>
  <p:slideViewPr>
    <p:cSldViewPr snapToGrid="0">
      <p:cViewPr varScale="1">
        <p:scale>
          <a:sx n="85" d="100"/>
          <a:sy n="85" d="100"/>
        </p:scale>
        <p:origin x="826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presProps" Target="presProps.xml"/><Relationship Id="rId30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8D2CC92-EE88-49E4-B7DF-7BA92629600A}" type="datetimeFigureOut">
              <a:rPr lang="zh-CN" altLang="en-US" smtClean="0"/>
              <a:t>2021/12/3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C04F5D8-B725-41EE-AA85-BBBC047C40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827000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zh-CN" altLang="en-US" dirty="0"/>
              <a:t>铁死亡</a:t>
            </a:r>
            <a:r>
              <a:rPr lang="en-US" altLang="zh-CN" dirty="0"/>
              <a:t>0.01genes</a:t>
            </a:r>
            <a:r>
              <a:rPr lang="zh-CN" altLang="en-US" dirty="0"/>
              <a:t>的预后模型：</a:t>
            </a:r>
            <a:endParaRPr lang="en-US" altLang="zh-CN" dirty="0"/>
          </a:p>
          <a:p>
            <a:r>
              <a:rPr lang="en-US" altLang="zh-CN" b="1" i="0" dirty="0" err="1">
                <a:solidFill>
                  <a:srgbClr val="000000"/>
                </a:solidFill>
                <a:effectLst/>
                <a:latin typeface="Microsoft YaHei" panose="020B0503020204020204" pitchFamily="34" charset="-122"/>
                <a:ea typeface="Microsoft YaHei" panose="020B0503020204020204" pitchFamily="34" charset="-122"/>
              </a:rPr>
              <a:t>lambda.min</a:t>
            </a:r>
            <a:r>
              <a:rPr lang="en-US" altLang="zh-CN" b="1" i="0" dirty="0">
                <a:solidFill>
                  <a:srgbClr val="000000"/>
                </a:solidFill>
                <a:effectLst/>
                <a:latin typeface="Microsoft YaHei" panose="020B0503020204020204" pitchFamily="34" charset="-122"/>
                <a:ea typeface="Microsoft YaHei" panose="020B0503020204020204" pitchFamily="34" charset="-122"/>
              </a:rPr>
              <a:t>=0.0236</a:t>
            </a:r>
            <a:br>
              <a:rPr lang="en-US" altLang="zh-CN" dirty="0"/>
            </a:br>
            <a:r>
              <a:rPr lang="en-US" altLang="zh-CN" b="1" i="0" dirty="0" err="1">
                <a:solidFill>
                  <a:srgbClr val="000000"/>
                </a:solidFill>
                <a:effectLst/>
                <a:latin typeface="Microsoft YaHei" panose="020B0503020204020204" pitchFamily="34" charset="-122"/>
                <a:ea typeface="Microsoft YaHei" panose="020B0503020204020204" pitchFamily="34" charset="-122"/>
              </a:rPr>
              <a:t>Riskscore</a:t>
            </a:r>
            <a:r>
              <a:rPr lang="en-US" altLang="zh-CN" b="1" i="0" dirty="0">
                <a:solidFill>
                  <a:srgbClr val="000000"/>
                </a:solidFill>
                <a:effectLst/>
                <a:latin typeface="Microsoft YaHei" panose="020B0503020204020204" pitchFamily="34" charset="-122"/>
                <a:ea typeface="Microsoft YaHei" panose="020B0503020204020204" pitchFamily="34" charset="-122"/>
              </a:rPr>
              <a:t>=(0.1218)*CARS1+(0.0359)*RPL8+(0.0095)*TFRC+(0.1585)*SLC7A11+(0.1652)*SLC1A5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C04F5D8-B725-41EE-AA85-BBBC047C400A}" type="slidenum">
              <a:rPr lang="zh-CN" altLang="en-US" smtClean="0"/>
              <a:t>7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454800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zh-CN" altLang="en-US" dirty="0"/>
              <a:t>凋亡焦亡铁死亡</a:t>
            </a:r>
            <a:r>
              <a:rPr lang="en-US" altLang="zh-CN" dirty="0"/>
              <a:t>0.01genes</a:t>
            </a:r>
            <a:r>
              <a:rPr lang="zh-CN" altLang="en-US" dirty="0"/>
              <a:t>预后模型</a:t>
            </a:r>
            <a:endParaRPr lang="en-US" altLang="zh-CN" dirty="0"/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C04F5D8-B725-41EE-AA85-BBBC047C400A}" type="slidenum">
              <a:rPr lang="zh-CN" altLang="en-US" smtClean="0"/>
              <a:t>2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934925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D3D1A0-F7B1-4A44-8A49-F9D1C022F495}" type="datetimeFigureOut">
              <a:rPr lang="zh-CN" altLang="en-US" smtClean="0"/>
              <a:t>2021/12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A01CE-A5CC-4B97-B034-3C20D8B9EDF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135511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D3D1A0-F7B1-4A44-8A49-F9D1C022F495}" type="datetimeFigureOut">
              <a:rPr lang="zh-CN" altLang="en-US" smtClean="0"/>
              <a:t>2021/12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A01CE-A5CC-4B97-B034-3C20D8B9EDF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57262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D3D1A0-F7B1-4A44-8A49-F9D1C022F495}" type="datetimeFigureOut">
              <a:rPr lang="zh-CN" altLang="en-US" smtClean="0"/>
              <a:t>2021/12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A01CE-A5CC-4B97-B034-3C20D8B9EDF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810328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D3D1A0-F7B1-4A44-8A49-F9D1C022F495}" type="datetimeFigureOut">
              <a:rPr lang="zh-CN" altLang="en-US" smtClean="0"/>
              <a:t>2021/12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A01CE-A5CC-4B97-B034-3C20D8B9EDF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38181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D3D1A0-F7B1-4A44-8A49-F9D1C022F495}" type="datetimeFigureOut">
              <a:rPr lang="zh-CN" altLang="en-US" smtClean="0"/>
              <a:t>2021/12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A01CE-A5CC-4B97-B034-3C20D8B9EDF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39019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D3D1A0-F7B1-4A44-8A49-F9D1C022F495}" type="datetimeFigureOut">
              <a:rPr lang="zh-CN" altLang="en-US" smtClean="0"/>
              <a:t>2021/12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A01CE-A5CC-4B97-B034-3C20D8B9EDF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754429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D3D1A0-F7B1-4A44-8A49-F9D1C022F495}" type="datetimeFigureOut">
              <a:rPr lang="zh-CN" altLang="en-US" smtClean="0"/>
              <a:t>2021/12/3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A01CE-A5CC-4B97-B034-3C20D8B9EDF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530870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D3D1A0-F7B1-4A44-8A49-F9D1C022F495}" type="datetimeFigureOut">
              <a:rPr lang="zh-CN" altLang="en-US" smtClean="0"/>
              <a:t>2021/12/3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A01CE-A5CC-4B97-B034-3C20D8B9EDF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51914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D3D1A0-F7B1-4A44-8A49-F9D1C022F495}" type="datetimeFigureOut">
              <a:rPr lang="zh-CN" altLang="en-US" smtClean="0"/>
              <a:t>2021/12/3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A01CE-A5CC-4B97-B034-3C20D8B9EDF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50920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D3D1A0-F7B1-4A44-8A49-F9D1C022F495}" type="datetimeFigureOut">
              <a:rPr lang="zh-CN" altLang="en-US" smtClean="0"/>
              <a:t>2021/12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A01CE-A5CC-4B97-B034-3C20D8B9EDF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49764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D3D1A0-F7B1-4A44-8A49-F9D1C022F495}" type="datetimeFigureOut">
              <a:rPr lang="zh-CN" altLang="en-US" smtClean="0"/>
              <a:t>2021/12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A01CE-A5CC-4B97-B034-3C20D8B9EDF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87672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D3D1A0-F7B1-4A44-8A49-F9D1C022F495}" type="datetimeFigureOut">
              <a:rPr lang="zh-CN" altLang="en-US" smtClean="0"/>
              <a:t>2021/12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4A01CE-A5CC-4B97-B034-3C20D8B9EDF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24916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png"/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7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9.png"/><Relationship Id="rId2" Type="http://schemas.openxmlformats.org/officeDocument/2006/relationships/image" Target="../media/image48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0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2.png"/><Relationship Id="rId2" Type="http://schemas.openxmlformats.org/officeDocument/2006/relationships/image" Target="../media/image5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3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5.png"/><Relationship Id="rId2" Type="http://schemas.openxmlformats.org/officeDocument/2006/relationships/image" Target="../media/image54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7.png"/><Relationship Id="rId4" Type="http://schemas.openxmlformats.org/officeDocument/2006/relationships/image" Target="../media/image56.png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8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0.png"/><Relationship Id="rId2" Type="http://schemas.openxmlformats.org/officeDocument/2006/relationships/image" Target="../media/image5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2.png"/><Relationship Id="rId4" Type="http://schemas.openxmlformats.org/officeDocument/2006/relationships/image" Target="../media/image61.pn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4.png"/><Relationship Id="rId2" Type="http://schemas.openxmlformats.org/officeDocument/2006/relationships/image" Target="../media/image6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5.png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6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67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png"/><Relationship Id="rId11" Type="http://schemas.openxmlformats.org/officeDocument/2006/relationships/image" Target="../media/image22.png"/><Relationship Id="rId5" Type="http://schemas.openxmlformats.org/officeDocument/2006/relationships/image" Target="../media/image16.png"/><Relationship Id="rId10" Type="http://schemas.openxmlformats.org/officeDocument/2006/relationships/image" Target="../media/image21.png"/><Relationship Id="rId4" Type="http://schemas.openxmlformats.org/officeDocument/2006/relationships/image" Target="../media/image15.png"/><Relationship Id="rId9" Type="http://schemas.openxmlformats.org/officeDocument/2006/relationships/image" Target="../media/image20.png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68.png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69.png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0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2.png"/><Relationship Id="rId4" Type="http://schemas.openxmlformats.org/officeDocument/2006/relationships/image" Target="../media/image71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8.png"/><Relationship Id="rId4" Type="http://schemas.openxmlformats.org/officeDocument/2006/relationships/image" Target="../media/image27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2.png"/><Relationship Id="rId4" Type="http://schemas.openxmlformats.org/officeDocument/2006/relationships/image" Target="../media/image31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emf"/><Relationship Id="rId2" Type="http://schemas.openxmlformats.org/officeDocument/2006/relationships/image" Target="../media/image33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5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9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png"/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3.png"/><Relationship Id="rId4" Type="http://schemas.openxmlformats.org/officeDocument/2006/relationships/image" Target="../media/image4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图片 50">
            <a:extLst>
              <a:ext uri="{FF2B5EF4-FFF2-40B4-BE49-F238E27FC236}">
                <a16:creationId xmlns:a16="http://schemas.microsoft.com/office/drawing/2014/main" id="{83ADED96-40F2-4F55-B7BD-589CD5D5CDF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0291" y="1313467"/>
            <a:ext cx="2160000" cy="2160000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8D278683-7331-480A-86A7-45E91BB3905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80291" y="7657524"/>
            <a:ext cx="2160000" cy="2160000"/>
          </a:xfrm>
          <a:prstGeom prst="rect">
            <a:avLst/>
          </a:prstGeom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9B864BF2-2F89-4BAC-AEDA-C2651B21967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20291" y="7610981"/>
            <a:ext cx="2160000" cy="2160000"/>
          </a:xfrm>
          <a:prstGeom prst="rect">
            <a:avLst/>
          </a:prstGeom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83C65702-4D20-48A0-835A-BBF063782DE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7251" y="7614667"/>
            <a:ext cx="2160000" cy="2160000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5F50EFCC-B7E6-48BE-992F-AC50714DCCF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80291" y="5544067"/>
            <a:ext cx="2160000" cy="2160000"/>
          </a:xfrm>
          <a:prstGeom prst="rect">
            <a:avLst/>
          </a:prstGeom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id="{01D19154-D30E-475B-A16F-D317CCAB3C72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20291" y="5544067"/>
            <a:ext cx="2160000" cy="2160000"/>
          </a:xfrm>
          <a:prstGeom prst="rect">
            <a:avLst/>
          </a:prstGeom>
        </p:spPr>
      </p:pic>
      <p:pic>
        <p:nvPicPr>
          <p:cNvPr id="35" name="图片 34">
            <a:extLst>
              <a:ext uri="{FF2B5EF4-FFF2-40B4-BE49-F238E27FC236}">
                <a16:creationId xmlns:a16="http://schemas.microsoft.com/office/drawing/2014/main" id="{B749AC33-4320-43D8-9613-7190C90176FF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0291" y="5544067"/>
            <a:ext cx="2160000" cy="2160000"/>
          </a:xfrm>
          <a:prstGeom prst="rect">
            <a:avLst/>
          </a:prstGeom>
        </p:spPr>
      </p:pic>
      <p:pic>
        <p:nvPicPr>
          <p:cNvPr id="37" name="图片 36">
            <a:extLst>
              <a:ext uri="{FF2B5EF4-FFF2-40B4-BE49-F238E27FC236}">
                <a16:creationId xmlns:a16="http://schemas.microsoft.com/office/drawing/2014/main" id="{5C69187C-624D-4F97-9FEB-D8BFE014263D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0291" y="3384067"/>
            <a:ext cx="2160000" cy="2160000"/>
          </a:xfrm>
          <a:prstGeom prst="rect">
            <a:avLst/>
          </a:prstGeom>
        </p:spPr>
      </p:pic>
      <p:pic>
        <p:nvPicPr>
          <p:cNvPr id="39" name="图片 38">
            <a:extLst>
              <a:ext uri="{FF2B5EF4-FFF2-40B4-BE49-F238E27FC236}">
                <a16:creationId xmlns:a16="http://schemas.microsoft.com/office/drawing/2014/main" id="{60CC6552-337A-425C-8CCD-39FE247EBBB3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20291" y="3384067"/>
            <a:ext cx="2160000" cy="2160000"/>
          </a:xfrm>
          <a:prstGeom prst="rect">
            <a:avLst/>
          </a:prstGeom>
        </p:spPr>
      </p:pic>
      <p:pic>
        <p:nvPicPr>
          <p:cNvPr id="41" name="图片 40">
            <a:extLst>
              <a:ext uri="{FF2B5EF4-FFF2-40B4-BE49-F238E27FC236}">
                <a16:creationId xmlns:a16="http://schemas.microsoft.com/office/drawing/2014/main" id="{0D70D0FF-D52F-469B-BA03-5474C0214D1D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80291" y="3384067"/>
            <a:ext cx="2160000" cy="2160000"/>
          </a:xfrm>
          <a:prstGeom prst="rect">
            <a:avLst/>
          </a:prstGeom>
        </p:spPr>
      </p:pic>
      <p:pic>
        <p:nvPicPr>
          <p:cNvPr id="43" name="图片 42">
            <a:extLst>
              <a:ext uri="{FF2B5EF4-FFF2-40B4-BE49-F238E27FC236}">
                <a16:creationId xmlns:a16="http://schemas.microsoft.com/office/drawing/2014/main" id="{45A69779-0497-4B76-B2B5-CE9167CB18FF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80291" y="1313467"/>
            <a:ext cx="2160000" cy="2160000"/>
          </a:xfrm>
          <a:prstGeom prst="rect">
            <a:avLst/>
          </a:prstGeom>
        </p:spPr>
      </p:pic>
      <p:sp>
        <p:nvSpPr>
          <p:cNvPr id="48" name="文本框 47">
            <a:extLst>
              <a:ext uri="{FF2B5EF4-FFF2-40B4-BE49-F238E27FC236}">
                <a16:creationId xmlns:a16="http://schemas.microsoft.com/office/drawing/2014/main" id="{66EEDF09-0A7C-4F32-A4DF-C8EF0B9419A2}"/>
              </a:ext>
            </a:extLst>
          </p:cNvPr>
          <p:cNvSpPr txBox="1"/>
          <p:nvPr/>
        </p:nvSpPr>
        <p:spPr>
          <a:xfrm>
            <a:off x="702477" y="215569"/>
            <a:ext cx="559562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800" b="1" dirty="0">
                <a:latin typeface="Arial" panose="020B0604020202020204" pitchFamily="34" charset="0"/>
                <a:cs typeface="Arial" panose="020B0604020202020204" pitchFamily="34" charset="0"/>
              </a:rPr>
              <a:t>Extended Data for Figure 2</a:t>
            </a:r>
            <a:endParaRPr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728BE61B-86A4-4AA2-A9A2-896B64E35425}"/>
              </a:ext>
            </a:extLst>
          </p:cNvPr>
          <p:cNvSpPr txBox="1"/>
          <p:nvPr/>
        </p:nvSpPr>
        <p:spPr>
          <a:xfrm>
            <a:off x="411767" y="762060"/>
            <a:ext cx="64472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b="1" dirty="0">
                <a:latin typeface="Arial" panose="020B0604020202020204" pitchFamily="34" charset="0"/>
                <a:cs typeface="Arial" panose="020B0604020202020204" pitchFamily="34" charset="0"/>
              </a:rPr>
              <a:t>2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0" name="图片 49">
            <a:extLst>
              <a:ext uri="{FF2B5EF4-FFF2-40B4-BE49-F238E27FC236}">
                <a16:creationId xmlns:a16="http://schemas.microsoft.com/office/drawing/2014/main" id="{74C73688-F4B2-490C-B3B0-FBABDAA25B5D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20291" y="1313467"/>
            <a:ext cx="2160000" cy="2160000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C1B51C23-1CF1-4614-AC58-F7F391C5111A}"/>
              </a:ext>
            </a:extLst>
          </p:cNvPr>
          <p:cNvSpPr txBox="1"/>
          <p:nvPr/>
        </p:nvSpPr>
        <p:spPr>
          <a:xfrm>
            <a:off x="1022511" y="959147"/>
            <a:ext cx="49888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22 genes significantly correlate with the OS rate (p&lt;0.05)</a:t>
            </a:r>
            <a:endParaRPr lang="zh-CN" altLang="en-US" sz="1400" dirty="0"/>
          </a:p>
        </p:txBody>
      </p:sp>
    </p:spTree>
    <p:extLst>
      <p:ext uri="{BB962C8B-B14F-4D97-AF65-F5344CB8AC3E}">
        <p14:creationId xmlns:p14="http://schemas.microsoft.com/office/powerpoint/2010/main" val="297198913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A6654CE9-C3D0-4EA9-A84D-69EBA9E7B1F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0361" y="1969427"/>
            <a:ext cx="4463906" cy="4320000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135DEF26-A5BC-4A7E-AF23-959C55ABF2AC}"/>
              </a:ext>
            </a:extLst>
          </p:cNvPr>
          <p:cNvSpPr txBox="1"/>
          <p:nvPr/>
        </p:nvSpPr>
        <p:spPr>
          <a:xfrm>
            <a:off x="528725" y="515156"/>
            <a:ext cx="190308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3C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, continued.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FCD2BFCA-19BB-4F23-9705-8EB42BDF0699}"/>
              </a:ext>
            </a:extLst>
          </p:cNvPr>
          <p:cNvSpPr txBox="1"/>
          <p:nvPr/>
        </p:nvSpPr>
        <p:spPr>
          <a:xfrm>
            <a:off x="423758" y="6422002"/>
            <a:ext cx="519711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he CIBERSORT analysis of immune cell infiltration among sub-groups.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2755881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ABD29379-03CA-4128-8027-82CA475E4565}"/>
              </a:ext>
            </a:extLst>
          </p:cNvPr>
          <p:cNvSpPr txBox="1"/>
          <p:nvPr/>
        </p:nvSpPr>
        <p:spPr>
          <a:xfrm>
            <a:off x="528725" y="958499"/>
            <a:ext cx="190308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3C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, continued.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94038C88-F221-46D2-AE1C-1B0637F93E6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76782" y="5605390"/>
            <a:ext cx="3418278" cy="2880000"/>
          </a:xfrm>
          <a:prstGeom prst="rect">
            <a:avLst/>
          </a:prstGeom>
        </p:spPr>
      </p:pic>
      <p:grpSp>
        <p:nvGrpSpPr>
          <p:cNvPr id="7" name="组合 6">
            <a:extLst>
              <a:ext uri="{FF2B5EF4-FFF2-40B4-BE49-F238E27FC236}">
                <a16:creationId xmlns:a16="http://schemas.microsoft.com/office/drawing/2014/main" id="{235EE5B5-FECB-483C-A8CE-9D027C2AB377}"/>
              </a:ext>
            </a:extLst>
          </p:cNvPr>
          <p:cNvGrpSpPr>
            <a:grpSpLocks noChangeAspect="1"/>
          </p:cNvGrpSpPr>
          <p:nvPr/>
        </p:nvGrpSpPr>
        <p:grpSpPr>
          <a:xfrm>
            <a:off x="528725" y="5710870"/>
            <a:ext cx="2012895" cy="2774518"/>
            <a:chOff x="5394288" y="7981020"/>
            <a:chExt cx="978418" cy="1348624"/>
          </a:xfrm>
        </p:grpSpPr>
        <p:pic>
          <p:nvPicPr>
            <p:cNvPr id="8" name="图片 7">
              <a:extLst>
                <a:ext uri="{FF2B5EF4-FFF2-40B4-BE49-F238E27FC236}">
                  <a16:creationId xmlns:a16="http://schemas.microsoft.com/office/drawing/2014/main" id="{B60081FD-DE88-4357-AA74-C11FDB66368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394288" y="8069644"/>
              <a:ext cx="978418" cy="1260000"/>
            </a:xfrm>
            <a:prstGeom prst="rect">
              <a:avLst/>
            </a:prstGeom>
          </p:spPr>
        </p:pic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FE9B0BFC-BE31-4FC5-B677-6CDAABE2993D}"/>
                </a:ext>
              </a:extLst>
            </p:cNvPr>
            <p:cNvSpPr txBox="1"/>
            <p:nvPr/>
          </p:nvSpPr>
          <p:spPr>
            <a:xfrm>
              <a:off x="5508134" y="7981020"/>
              <a:ext cx="596228" cy="1346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ICB Response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10" name="图片 9">
            <a:extLst>
              <a:ext uri="{FF2B5EF4-FFF2-40B4-BE49-F238E27FC236}">
                <a16:creationId xmlns:a16="http://schemas.microsoft.com/office/drawing/2014/main" id="{1AC69A62-C2B9-4436-B120-C9082395243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8725" y="1925119"/>
            <a:ext cx="5436411" cy="2480625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2C74B901-908C-4637-B18C-18D0EDEC8290}"/>
              </a:ext>
            </a:extLst>
          </p:cNvPr>
          <p:cNvSpPr txBox="1"/>
          <p:nvPr/>
        </p:nvSpPr>
        <p:spPr>
          <a:xfrm>
            <a:off x="528725" y="4405744"/>
            <a:ext cx="60365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omparison of checkpoint molecule expression among 4 sub-groups.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6D60D2EF-891B-4933-AD92-6B8B182D3B42}"/>
              </a:ext>
            </a:extLst>
          </p:cNvPr>
          <p:cNvSpPr txBox="1"/>
          <p:nvPr/>
        </p:nvSpPr>
        <p:spPr>
          <a:xfrm>
            <a:off x="354395" y="8883676"/>
            <a:ext cx="255413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he difference of 4 sub-groups responds to immune checkpoint blockade.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AAD19A56-09C4-47E0-8314-CB8A482BB87B}"/>
              </a:ext>
            </a:extLst>
          </p:cNvPr>
          <p:cNvSpPr txBox="1"/>
          <p:nvPr/>
        </p:nvSpPr>
        <p:spPr>
          <a:xfrm>
            <a:off x="3246930" y="8883676"/>
            <a:ext cx="3332389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he comparison of overall survival among 4 sub-groups, showing significant difference.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8814067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6285445F-F7AC-4E6D-952F-8D702028D0B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445" y="4903866"/>
            <a:ext cx="6833109" cy="4555406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3951835D-4617-4386-A8DF-0847D852BC6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24" y="2508242"/>
            <a:ext cx="3672000" cy="244800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CF341FCC-4A27-4766-B1D7-647DE3CA98B2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346"/>
          <a:stretch/>
        </p:blipFill>
        <p:spPr>
          <a:xfrm>
            <a:off x="3436444" y="2546342"/>
            <a:ext cx="3409110" cy="2376000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27D2ED50-7225-481E-8D1F-327106A124B5}"/>
              </a:ext>
            </a:extLst>
          </p:cNvPr>
          <p:cNvSpPr txBox="1"/>
          <p:nvPr/>
        </p:nvSpPr>
        <p:spPr>
          <a:xfrm>
            <a:off x="503325" y="615439"/>
            <a:ext cx="57900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3D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内容占位符 2">
            <a:extLst>
              <a:ext uri="{FF2B5EF4-FFF2-40B4-BE49-F238E27FC236}">
                <a16:creationId xmlns:a16="http://schemas.microsoft.com/office/drawing/2014/main" id="{92ADFAA6-2470-49CC-B941-A72180B52E4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36419" y="1015216"/>
            <a:ext cx="6179126" cy="1274087"/>
          </a:xfrm>
        </p:spPr>
        <p:txBody>
          <a:bodyPr>
            <a:normAutofit lnSpcReduction="10000"/>
          </a:bodyPr>
          <a:lstStyle/>
          <a:p>
            <a:pPr marL="0" indent="0">
              <a:lnSpc>
                <a:spcPct val="100000"/>
              </a:lnSpc>
              <a:buNone/>
            </a:pPr>
            <a:r>
              <a:rPr lang="en-GB" altLang="zh-CN" sz="14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he prognostic signature model was obtained based on 5 ferroptosis genes with p</a:t>
            </a:r>
            <a:r>
              <a:rPr lang="zh-CN" altLang="zh-CN" sz="14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≤</a:t>
            </a:r>
            <a:r>
              <a:rPr lang="en-GB" altLang="zh-CN" sz="14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0.01 correlation with OS and the LASSO Cox regression algorithm. The obtained </a:t>
            </a:r>
            <a:r>
              <a:rPr lang="el-GR" altLang="zh-CN" sz="14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λ</a:t>
            </a:r>
            <a:r>
              <a:rPr lang="en-US" altLang="zh-CN" sz="1400" i="0" baseline="-25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min</a:t>
            </a:r>
            <a:r>
              <a:rPr lang="en-US" altLang="zh-CN" sz="1400" i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=0.0236.The obtained </a:t>
            </a:r>
            <a:r>
              <a:rPr lang="en-US" altLang="zh-CN" sz="1400" i="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Riskscore</a:t>
            </a:r>
            <a:r>
              <a:rPr lang="en-US" altLang="zh-CN" sz="1400" i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  = (0.1218)*CARS1+ (0.0359)*RPL8+(0.0095)*TFRC+(0.1585)*SLC7A11+(0.1652)*SLC1A5. The correlation between </a:t>
            </a:r>
            <a:r>
              <a:rPr lang="en-US" altLang="zh-CN" sz="1400" i="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Riskscore</a:t>
            </a:r>
            <a:r>
              <a:rPr lang="en-US" altLang="zh-CN" sz="1400" i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 and overall survival/status is shown in the middle right graph.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2305745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C563696C-AF43-4CFF-9D72-EFC4867367E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92435" y="2073000"/>
            <a:ext cx="2880000" cy="288000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7AF32C25-27F7-4509-AA67-FD68B157CE0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5565" y="2073000"/>
            <a:ext cx="2880000" cy="288000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C3F31D07-505A-4C74-B6FA-81A09A347C4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5565" y="5098120"/>
            <a:ext cx="2880000" cy="2880000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543DB3F0-7FA8-4CAA-84E0-F1B06360A752}"/>
              </a:ext>
            </a:extLst>
          </p:cNvPr>
          <p:cNvSpPr txBox="1"/>
          <p:nvPr/>
        </p:nvSpPr>
        <p:spPr>
          <a:xfrm>
            <a:off x="702477" y="215569"/>
            <a:ext cx="559562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800" b="1" dirty="0">
                <a:latin typeface="Arial" panose="020B0604020202020204" pitchFamily="34" charset="0"/>
                <a:cs typeface="Arial" panose="020B0604020202020204" pitchFamily="34" charset="0"/>
              </a:rPr>
              <a:t>Extended Data for Figure 4</a:t>
            </a:r>
            <a:endParaRPr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CA5FF0E4-23C7-4180-9E6B-6DA13F88F693}"/>
              </a:ext>
            </a:extLst>
          </p:cNvPr>
          <p:cNvSpPr txBox="1"/>
          <p:nvPr/>
        </p:nvSpPr>
        <p:spPr>
          <a:xfrm>
            <a:off x="412974" y="1611335"/>
            <a:ext cx="57900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4A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421F0399-2F01-46E1-BCCE-F63C4704F8D1}"/>
              </a:ext>
            </a:extLst>
          </p:cNvPr>
          <p:cNvSpPr txBox="1"/>
          <p:nvPr/>
        </p:nvSpPr>
        <p:spPr>
          <a:xfrm>
            <a:off x="3710675" y="5825546"/>
            <a:ext cx="286176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dditional survival curves of </a:t>
            </a:r>
            <a:r>
              <a:rPr lang="en-US" altLang="zh-CN" dirty="0" err="1"/>
              <a:t>pyroptosis</a:t>
            </a:r>
            <a:r>
              <a:rPr lang="en-US" altLang="zh-CN" dirty="0"/>
              <a:t> marker genes CASP3, PLCG1, NLRC4. p&lt;0.05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74398702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图片 9">
            <a:extLst>
              <a:ext uri="{FF2B5EF4-FFF2-40B4-BE49-F238E27FC236}">
                <a16:creationId xmlns:a16="http://schemas.microsoft.com/office/drawing/2014/main" id="{0FF961EC-57D6-4090-B0C4-A62D0963833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212" y="1713569"/>
            <a:ext cx="4320000" cy="2160000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955601FB-9BF4-4CD6-B05E-66FC153D76E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757" y="3873569"/>
            <a:ext cx="2880000" cy="2880000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442B3BB4-28F5-4E00-BFAB-AE4F8DF208D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1212" y="1829519"/>
            <a:ext cx="2400000" cy="1800000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582C3E4C-84C5-46EC-9DEE-CF19A1B4EBE7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24846" y="3873569"/>
            <a:ext cx="2880000" cy="2880000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2D9A31EC-400C-4509-BEF9-D8017370EFBE}"/>
              </a:ext>
            </a:extLst>
          </p:cNvPr>
          <p:cNvSpPr txBox="1"/>
          <p:nvPr/>
        </p:nvSpPr>
        <p:spPr>
          <a:xfrm>
            <a:off x="322042" y="374228"/>
            <a:ext cx="57900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4B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0" name="表格 19">
            <a:extLst>
              <a:ext uri="{FF2B5EF4-FFF2-40B4-BE49-F238E27FC236}">
                <a16:creationId xmlns:a16="http://schemas.microsoft.com/office/drawing/2014/main" id="{9F3E5C50-8368-4F50-9B64-B1796996ABB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91006765"/>
              </p:ext>
            </p:extLst>
          </p:nvPr>
        </p:nvGraphicFramePr>
        <p:xfrm>
          <a:off x="611545" y="7497630"/>
          <a:ext cx="5634910" cy="22098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395341">
                  <a:extLst>
                    <a:ext uri="{9D8B030D-6E8A-4147-A177-3AD203B41FA5}">
                      <a16:colId xmlns:a16="http://schemas.microsoft.com/office/drawing/2014/main" val="1465345075"/>
                    </a:ext>
                  </a:extLst>
                </a:gridCol>
                <a:gridCol w="1940707">
                  <a:extLst>
                    <a:ext uri="{9D8B030D-6E8A-4147-A177-3AD203B41FA5}">
                      <a16:colId xmlns:a16="http://schemas.microsoft.com/office/drawing/2014/main" val="848482592"/>
                    </a:ext>
                  </a:extLst>
                </a:gridCol>
                <a:gridCol w="1149431">
                  <a:extLst>
                    <a:ext uri="{9D8B030D-6E8A-4147-A177-3AD203B41FA5}">
                      <a16:colId xmlns:a16="http://schemas.microsoft.com/office/drawing/2014/main" val="2019392627"/>
                    </a:ext>
                  </a:extLst>
                </a:gridCol>
                <a:gridCol w="1149431">
                  <a:extLst>
                    <a:ext uri="{9D8B030D-6E8A-4147-A177-3AD203B41FA5}">
                      <a16:colId xmlns:a16="http://schemas.microsoft.com/office/drawing/2014/main" val="1340248624"/>
                    </a:ext>
                  </a:extLst>
                </a:gridCol>
              </a:tblGrid>
              <a:tr h="182880"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crosoft YaHei" panose="020B0503020204020204" pitchFamily="34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zh-C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Describe</a:t>
                      </a:r>
                    </a:p>
                  </a:txBody>
                  <a:tcPr marL="7620" marR="7620" marT="762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1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crosoft YaHei" panose="020B0503020204020204" pitchFamily="34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2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crosoft YaHei" panose="020B0503020204020204" pitchFamily="34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32228003"/>
                  </a:ext>
                </a:extLst>
              </a:tr>
              <a:tr h="17526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tus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crosoft YaHei" panose="020B0503020204020204" pitchFamily="34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ive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crosoft YaHei" panose="020B0503020204020204" pitchFamily="34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5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crosoft YaHei" panose="020B0503020204020204" pitchFamily="34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crosoft YaHei" panose="020B0503020204020204" pitchFamily="34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71627122"/>
                  </a:ext>
                </a:extLst>
              </a:tr>
              <a:tr h="175260"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crosoft YaHei" panose="020B0503020204020204" pitchFamily="34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ad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crosoft YaHei" panose="020B0503020204020204" pitchFamily="34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</a:t>
                      </a:r>
                      <a:endParaRPr lang="en-US" altLang="zh-CN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crosoft YaHei" panose="020B0503020204020204" pitchFamily="34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</a:t>
                      </a:r>
                      <a:endParaRPr lang="en-US" altLang="zh-CN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crosoft YaHei" panose="020B0503020204020204" pitchFamily="34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18312722"/>
                  </a:ext>
                </a:extLst>
              </a:tr>
              <a:tr h="17526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crosoft YaHei" panose="020B0503020204020204" pitchFamily="34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(SD)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crosoft YaHei" panose="020B0503020204020204" pitchFamily="34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.6 (13.3)</a:t>
                      </a:r>
                      <a:endParaRPr lang="en-US" altLang="zh-CN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crosoft YaHei" panose="020B0503020204020204" pitchFamily="34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.8 (14.5)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crosoft YaHei" panose="020B0503020204020204" pitchFamily="34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91387923"/>
                  </a:ext>
                </a:extLst>
              </a:tr>
              <a:tr h="175260"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crosoft YaHei" panose="020B0503020204020204" pitchFamily="34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[MIN,MAX]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crosoft YaHei" panose="020B0503020204020204" pitchFamily="34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 [16,90]</a:t>
                      </a:r>
                      <a:endParaRPr lang="en-US" altLang="zh-CN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crosoft YaHei" panose="020B0503020204020204" pitchFamily="34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 [17,85]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crosoft YaHei" panose="020B0503020204020204" pitchFamily="34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37950709"/>
                  </a:ext>
                </a:extLst>
              </a:tr>
              <a:tr h="17526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der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crosoft YaHei" panose="020B0503020204020204" pitchFamily="34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MALE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crosoft YaHei" panose="020B0503020204020204" pitchFamily="34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6</a:t>
                      </a:r>
                      <a:endParaRPr lang="en-US" altLang="zh-CN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crosoft YaHei" panose="020B0503020204020204" pitchFamily="34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</a:t>
                      </a:r>
                      <a:endParaRPr lang="en-US" altLang="zh-CN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crosoft YaHei" panose="020B0503020204020204" pitchFamily="34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96785597"/>
                  </a:ext>
                </a:extLst>
              </a:tr>
              <a:tr h="175260"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crosoft YaHei" panose="020B0503020204020204" pitchFamily="34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E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crosoft YaHei" panose="020B0503020204020204" pitchFamily="34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9</a:t>
                      </a:r>
                      <a:endParaRPr lang="en-US" altLang="zh-CN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crosoft YaHei" panose="020B0503020204020204" pitchFamily="34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</a:t>
                      </a:r>
                      <a:endParaRPr lang="en-US" altLang="zh-CN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crosoft YaHei" panose="020B0503020204020204" pitchFamily="34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75427941"/>
                  </a:ext>
                </a:extLst>
              </a:tr>
              <a:tr h="175260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NM_stage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crosoft YaHei" panose="020B0503020204020204" pitchFamily="34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crosoft YaHei" panose="020B0503020204020204" pitchFamily="34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5</a:t>
                      </a:r>
                      <a:endParaRPr lang="en-US" altLang="zh-CN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crosoft YaHei" panose="020B0503020204020204" pitchFamily="34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</a:t>
                      </a:r>
                      <a:endParaRPr lang="en-US" altLang="zh-CN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crosoft YaHei" panose="020B0503020204020204" pitchFamily="34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69034209"/>
                  </a:ext>
                </a:extLst>
              </a:tr>
              <a:tr h="175260"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crosoft YaHei" panose="020B0503020204020204" pitchFamily="34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I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crosoft YaHei" panose="020B0503020204020204" pitchFamily="34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</a:t>
                      </a:r>
                      <a:endParaRPr lang="en-US" altLang="zh-CN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crosoft YaHei" panose="020B0503020204020204" pitchFamily="34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crosoft YaHei" panose="020B0503020204020204" pitchFamily="34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9108604"/>
                  </a:ext>
                </a:extLst>
              </a:tr>
              <a:tr h="175260"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crosoft YaHei" panose="020B0503020204020204" pitchFamily="34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II-IV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crosoft YaHei" panose="020B0503020204020204" pitchFamily="34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crosoft YaHei" panose="020B0503020204020204" pitchFamily="34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icrosoft YaHei" panose="020B0503020204020204" pitchFamily="34" charset="-122"/>
                          <a:cs typeface="Arial" panose="020B0604020202020204" pitchFamily="34" charset="0"/>
                        </a:rPr>
                        <a:t>22</a:t>
                      </a:r>
                      <a:endParaRPr lang="zh-CN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crosoft YaHei" panose="020B0503020204020204" pitchFamily="34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247075"/>
                  </a:ext>
                </a:extLst>
              </a:tr>
            </a:tbl>
          </a:graphicData>
        </a:graphic>
      </p:graphicFrame>
      <p:sp>
        <p:nvSpPr>
          <p:cNvPr id="21" name="文本框 20">
            <a:extLst>
              <a:ext uri="{FF2B5EF4-FFF2-40B4-BE49-F238E27FC236}">
                <a16:creationId xmlns:a16="http://schemas.microsoft.com/office/drawing/2014/main" id="{8303B5FB-4BD0-4965-A914-0E6765F24F20}"/>
              </a:ext>
            </a:extLst>
          </p:cNvPr>
          <p:cNvSpPr txBox="1"/>
          <p:nvPr/>
        </p:nvSpPr>
        <p:spPr>
          <a:xfrm>
            <a:off x="576253" y="7151625"/>
            <a:ext cx="46746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Basic clinical information of 2 sub-clustered patients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7B939227-6B65-4F30-AF0B-B2C7BC23F100}"/>
              </a:ext>
            </a:extLst>
          </p:cNvPr>
          <p:cNvSpPr txBox="1"/>
          <p:nvPr/>
        </p:nvSpPr>
        <p:spPr>
          <a:xfrm>
            <a:off x="310543" y="922853"/>
            <a:ext cx="659829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HCC samples were sub-clustered into 2 groups based on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pyroptosis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marker genes. The basic clinical information of three sub-clustered patients is shown in the table.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144729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文本框 13">
            <a:extLst>
              <a:ext uri="{FF2B5EF4-FFF2-40B4-BE49-F238E27FC236}">
                <a16:creationId xmlns:a16="http://schemas.microsoft.com/office/drawing/2014/main" id="{FBEB3CD5-89D2-49EC-8C7E-F9E276E6C949}"/>
              </a:ext>
            </a:extLst>
          </p:cNvPr>
          <p:cNvSpPr txBox="1"/>
          <p:nvPr/>
        </p:nvSpPr>
        <p:spPr>
          <a:xfrm>
            <a:off x="412376" y="1732553"/>
            <a:ext cx="6187440" cy="6987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Expressions of checkpoint molecules. Histogram of checkpoint molecule expression among 2 sub-groups.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EE2FF427-E5A7-4506-802B-24D66CDB23AE}"/>
              </a:ext>
            </a:extLst>
          </p:cNvPr>
          <p:cNvSpPr txBox="1"/>
          <p:nvPr/>
        </p:nvSpPr>
        <p:spPr>
          <a:xfrm>
            <a:off x="331699" y="562676"/>
            <a:ext cx="57900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4C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图片 15">
            <a:extLst>
              <a:ext uri="{FF2B5EF4-FFF2-40B4-BE49-F238E27FC236}">
                <a16:creationId xmlns:a16="http://schemas.microsoft.com/office/drawing/2014/main" id="{723B4641-E863-4C05-A1CF-4C9C76E70F5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6927" y="2666662"/>
            <a:ext cx="5120280" cy="29730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74448203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E48BF4A2-A374-4324-B479-D4DE77F1C3B6}"/>
              </a:ext>
            </a:extLst>
          </p:cNvPr>
          <p:cNvSpPr txBox="1"/>
          <p:nvPr/>
        </p:nvSpPr>
        <p:spPr>
          <a:xfrm>
            <a:off x="445072" y="1994424"/>
            <a:ext cx="23213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Immune score (TIMER)</a:t>
            </a:r>
            <a:endParaRPr lang="zh-CN" altLang="en-US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EA4CA13F-7DEF-48BB-AECE-8E1790122874}"/>
              </a:ext>
            </a:extLst>
          </p:cNvPr>
          <p:cNvSpPr txBox="1"/>
          <p:nvPr/>
        </p:nvSpPr>
        <p:spPr>
          <a:xfrm>
            <a:off x="3790974" y="1994382"/>
            <a:ext cx="27504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Immune score (CIBERSORT)</a:t>
            </a:r>
            <a:endParaRPr lang="zh-CN" altLang="en-US" dirty="0"/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9398A3FC-AFF3-42BB-A544-4B5F3C27A30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7772" y="2343436"/>
            <a:ext cx="3201228" cy="3193057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79816FAF-2AE5-4E2D-AA58-194B2EC539F2}"/>
              </a:ext>
            </a:extLst>
          </p:cNvPr>
          <p:cNvSpPr txBox="1"/>
          <p:nvPr/>
        </p:nvSpPr>
        <p:spPr>
          <a:xfrm>
            <a:off x="445072" y="133976"/>
            <a:ext cx="57900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4D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7E2FA408-327E-44CF-95F6-1A25765BA9D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90973" y="2363713"/>
            <a:ext cx="3004273" cy="3237849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D263C08C-3E07-4BBB-8452-5B55A974EB9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4870" y="6271328"/>
            <a:ext cx="1676966" cy="3069165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31505D0A-A3AB-4E1F-8EFD-6BDC733D5DE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47782" y="6415712"/>
            <a:ext cx="3393689" cy="2924781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1A5F622C-EDB7-4D02-864F-F489F09E756D}"/>
              </a:ext>
            </a:extLst>
          </p:cNvPr>
          <p:cNvSpPr txBox="1"/>
          <p:nvPr/>
        </p:nvSpPr>
        <p:spPr>
          <a:xfrm>
            <a:off x="445072" y="671477"/>
            <a:ext cx="6108128" cy="10218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Heatmaps and histograms of Immune cell infiltration (score, TIMER and CIBERSORT algorithm), response of immune checkpoint blockade, as well as curves of overall survival between the two sub-groups.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3466501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图片 11">
            <a:extLst>
              <a:ext uri="{FF2B5EF4-FFF2-40B4-BE49-F238E27FC236}">
                <a16:creationId xmlns:a16="http://schemas.microsoft.com/office/drawing/2014/main" id="{27C86C7A-96CD-458A-AB1C-50F753E07BF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1461" y="5041062"/>
            <a:ext cx="6453393" cy="4302262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24130EEB-3C17-4507-B8A7-A356DB3659F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883" r="6994" b="5463"/>
          <a:stretch/>
        </p:blipFill>
        <p:spPr>
          <a:xfrm>
            <a:off x="281461" y="2999825"/>
            <a:ext cx="3107655" cy="1908000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DA2D95C7-688A-469C-BF32-D0CB15BD3B6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646" r="5368" b="5699"/>
          <a:stretch/>
        </p:blipFill>
        <p:spPr>
          <a:xfrm>
            <a:off x="3522615" y="2999825"/>
            <a:ext cx="3162001" cy="1908000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DC48635D-23CC-4315-A12F-857F0E2036EC}"/>
              </a:ext>
            </a:extLst>
          </p:cNvPr>
          <p:cNvSpPr txBox="1"/>
          <p:nvPr/>
        </p:nvSpPr>
        <p:spPr>
          <a:xfrm>
            <a:off x="331699" y="562676"/>
            <a:ext cx="5613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4E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内容占位符 2">
            <a:extLst>
              <a:ext uri="{FF2B5EF4-FFF2-40B4-BE49-F238E27FC236}">
                <a16:creationId xmlns:a16="http://schemas.microsoft.com/office/drawing/2014/main" id="{7D8EEF72-DBB4-4F3B-B4F4-F7E3CEBE9A1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3998" y="1010921"/>
            <a:ext cx="6350856" cy="1646761"/>
          </a:xfrm>
        </p:spPr>
        <p:txBody>
          <a:bodyPr>
            <a:noAutofit/>
          </a:bodyPr>
          <a:lstStyle/>
          <a:p>
            <a:pPr marL="0" indent="0">
              <a:lnSpc>
                <a:spcPct val="150000"/>
              </a:lnSpc>
              <a:buNone/>
            </a:pPr>
            <a:r>
              <a:rPr lang="en-GB" altLang="zh-CN" sz="14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he prognostic signature model was obtained based on 3 </a:t>
            </a:r>
            <a:r>
              <a:rPr lang="en-GB" altLang="zh-CN" sz="14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yroptosis</a:t>
            </a:r>
            <a:r>
              <a:rPr lang="en-GB" altLang="zh-CN" sz="14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genes with p</a:t>
            </a:r>
            <a:r>
              <a:rPr lang="zh-CN" altLang="zh-CN" sz="14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≤</a:t>
            </a:r>
            <a:r>
              <a:rPr lang="en-GB" altLang="zh-CN" sz="14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0.01 correlation with OS and the LASSO Cox regression algorithm. The obtained </a:t>
            </a:r>
            <a:r>
              <a:rPr lang="el-GR" altLang="zh-CN" sz="14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λ</a:t>
            </a:r>
            <a:r>
              <a:rPr lang="en-US" altLang="zh-CN" sz="1400" i="0" baseline="-25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min</a:t>
            </a:r>
            <a:r>
              <a:rPr lang="en-US" altLang="zh-CN" sz="1400" i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=0.0029.The obtained </a:t>
            </a:r>
            <a:r>
              <a:rPr lang="en-US" altLang="zh-CN" sz="1400" i="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Riskscore</a:t>
            </a:r>
            <a:r>
              <a:rPr lang="en-US" altLang="zh-CN" sz="1400" i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  = </a:t>
            </a:r>
            <a:r>
              <a:rPr lang="en-US" altLang="zh-CN" sz="1400" i="0" dirty="0">
                <a:solidFill>
                  <a:srgbClr val="000000"/>
                </a:solidFill>
                <a:effectLst/>
                <a:latin typeface="Microsoft YaHei" panose="020B0503020204020204" pitchFamily="34" charset="-122"/>
                <a:ea typeface="Microsoft YaHei" panose="020B0503020204020204" pitchFamily="34" charset="-122"/>
              </a:rPr>
              <a:t>(0.2413)*GSDME+(-0.2142)*NLRP6+(0.0892)*NOD1</a:t>
            </a:r>
            <a:r>
              <a:rPr lang="en-US" altLang="zh-CN" sz="1400" i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. The correlation between </a:t>
            </a:r>
            <a:r>
              <a:rPr lang="en-US" altLang="zh-CN" sz="1400" i="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Riskscore</a:t>
            </a:r>
            <a:r>
              <a:rPr lang="en-US" altLang="zh-CN" sz="1400" i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 and overall survival/status is shown in the middle right graph.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93956958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>
            <a:extLst>
              <a:ext uri="{FF2B5EF4-FFF2-40B4-BE49-F238E27FC236}">
                <a16:creationId xmlns:a16="http://schemas.microsoft.com/office/drawing/2014/main" id="{18D4EFA8-C1A5-4A22-82A6-C58FBE6A0F3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534" r="7829"/>
          <a:stretch/>
        </p:blipFill>
        <p:spPr>
          <a:xfrm>
            <a:off x="46516" y="2430895"/>
            <a:ext cx="6811484" cy="6108123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D37DF45E-6476-461C-B41B-DB5CFF7BF77D}"/>
              </a:ext>
            </a:extLst>
          </p:cNvPr>
          <p:cNvSpPr txBox="1"/>
          <p:nvPr/>
        </p:nvSpPr>
        <p:spPr>
          <a:xfrm>
            <a:off x="702477" y="215569"/>
            <a:ext cx="559562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800" b="1" dirty="0">
                <a:latin typeface="Arial" panose="020B0604020202020204" pitchFamily="34" charset="0"/>
                <a:cs typeface="Arial" panose="020B0604020202020204" pitchFamily="34" charset="0"/>
              </a:rPr>
              <a:t>Extended Data for Figure 5</a:t>
            </a:r>
            <a:endParaRPr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DF199C39-C0A4-4C11-9A79-0163D13BAF85}"/>
              </a:ext>
            </a:extLst>
          </p:cNvPr>
          <p:cNvSpPr txBox="1"/>
          <p:nvPr/>
        </p:nvSpPr>
        <p:spPr>
          <a:xfrm>
            <a:off x="270392" y="1365246"/>
            <a:ext cx="57900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5A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A348A934-4B5A-422F-B4D4-5698A5CAA656}"/>
              </a:ext>
            </a:extLst>
          </p:cNvPr>
          <p:cNvSpPr txBox="1"/>
          <p:nvPr/>
        </p:nvSpPr>
        <p:spPr>
          <a:xfrm>
            <a:off x="799463" y="1606890"/>
            <a:ext cx="5498642" cy="6987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he multi-gene correlation of apoptosis, ferroptosis and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pyroptosis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marker genes that have significant correlation with the OS (p&lt;0.05 ).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22610364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A4F669E2-0DD0-4F25-B7B7-47D8B33E668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389365"/>
            <a:ext cx="6858000" cy="5908075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C7ED43DA-8BAF-41C7-B0C2-78B23ED6CDEE}"/>
              </a:ext>
            </a:extLst>
          </p:cNvPr>
          <p:cNvSpPr txBox="1"/>
          <p:nvPr/>
        </p:nvSpPr>
        <p:spPr>
          <a:xfrm>
            <a:off x="409805" y="521571"/>
            <a:ext cx="57900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5B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02809A23-5B76-4CE9-ADE4-9E39AA415E5A}"/>
              </a:ext>
            </a:extLst>
          </p:cNvPr>
          <p:cNvSpPr txBox="1"/>
          <p:nvPr/>
        </p:nvSpPr>
        <p:spPr>
          <a:xfrm>
            <a:off x="305388" y="1081588"/>
            <a:ext cx="655261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rotein-protein correlation of those genes that have p&lt;0.05 correlation with the OS rate.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235837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F1139825-9D4A-4F65-A950-317F608BDE7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98000" y="7379796"/>
            <a:ext cx="2160000" cy="216000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6BE5C6DE-02A3-4959-85E0-72E1BEEFA2E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5458" y="5219796"/>
            <a:ext cx="2160000" cy="2160000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B07CA1EE-380A-4A80-A02B-C62372B48D6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98000" y="3059796"/>
            <a:ext cx="2160000" cy="216000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0E39F808-F355-436A-8A8B-0EF23000E97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76076" y="3059796"/>
            <a:ext cx="2160000" cy="2160000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D932C5BA-88E3-46CD-97D4-EDC46322F65D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5458" y="3059796"/>
            <a:ext cx="2160000" cy="2160000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FF00E89D-7A30-4C25-B766-8FF61A7AFA80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98000" y="899796"/>
            <a:ext cx="2160000" cy="2160000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670DFC6B-5B53-4AC0-BD7C-5D75CB3C8293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1729" y="899796"/>
            <a:ext cx="2160000" cy="2160000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39D66B5E-ACC4-4F6F-A313-1D5844C46D64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5458" y="899796"/>
            <a:ext cx="2160000" cy="2160000"/>
          </a:xfrm>
          <a:prstGeom prst="rect">
            <a:avLst/>
          </a:prstGeom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id="{C669400C-CAFC-48D6-9C77-E41BF94E3DF5}"/>
              </a:ext>
            </a:extLst>
          </p:cNvPr>
          <p:cNvSpPr txBox="1"/>
          <p:nvPr/>
        </p:nvSpPr>
        <p:spPr>
          <a:xfrm>
            <a:off x="411767" y="381386"/>
            <a:ext cx="223651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b="1" dirty="0">
                <a:latin typeface="Arial" panose="020B0604020202020204" pitchFamily="34" charset="0"/>
                <a:cs typeface="Arial" panose="020B0604020202020204" pitchFamily="34" charset="0"/>
              </a:rPr>
              <a:t>2A</a:t>
            </a:r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, continued.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图片 14">
            <a:extLst>
              <a:ext uri="{FF2B5EF4-FFF2-40B4-BE49-F238E27FC236}">
                <a16:creationId xmlns:a16="http://schemas.microsoft.com/office/drawing/2014/main" id="{E9C5FC32-B04A-4A8D-89D1-F42FFE7A98E9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7902" y="7379796"/>
            <a:ext cx="2160000" cy="2160000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400F12A1-D090-4FBD-B566-653840B75820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92951" y="7379796"/>
            <a:ext cx="2160000" cy="2160000"/>
          </a:xfrm>
          <a:prstGeom prst="rect">
            <a:avLst/>
          </a:prstGeom>
        </p:spPr>
      </p:pic>
      <p:sp>
        <p:nvSpPr>
          <p:cNvPr id="17" name="矩形 16">
            <a:extLst>
              <a:ext uri="{FF2B5EF4-FFF2-40B4-BE49-F238E27FC236}">
                <a16:creationId xmlns:a16="http://schemas.microsoft.com/office/drawing/2014/main" id="{5AD9E6F1-D057-4E7D-854A-9AA46D0CD3A4}"/>
              </a:ext>
            </a:extLst>
          </p:cNvPr>
          <p:cNvSpPr/>
          <p:nvPr/>
        </p:nvSpPr>
        <p:spPr>
          <a:xfrm>
            <a:off x="196949" y="7450136"/>
            <a:ext cx="6588000" cy="212400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BBDE0AD5-86AB-4B70-AB10-8D5506851462}"/>
              </a:ext>
            </a:extLst>
          </p:cNvPr>
          <p:cNvSpPr txBox="1"/>
          <p:nvPr/>
        </p:nvSpPr>
        <p:spPr>
          <a:xfrm>
            <a:off x="873760" y="9524614"/>
            <a:ext cx="49273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Expression of these 3 genes downregulated in HCC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09592165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F1EFD806-25EE-45CD-9203-9F2BC764A86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85984994"/>
              </p:ext>
            </p:extLst>
          </p:nvPr>
        </p:nvGraphicFramePr>
        <p:xfrm>
          <a:off x="3343562" y="730684"/>
          <a:ext cx="3066474" cy="89165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22158">
                  <a:extLst>
                    <a:ext uri="{9D8B030D-6E8A-4147-A177-3AD203B41FA5}">
                      <a16:colId xmlns:a16="http://schemas.microsoft.com/office/drawing/2014/main" val="914943830"/>
                    </a:ext>
                  </a:extLst>
                </a:gridCol>
                <a:gridCol w="1022158">
                  <a:extLst>
                    <a:ext uri="{9D8B030D-6E8A-4147-A177-3AD203B41FA5}">
                      <a16:colId xmlns:a16="http://schemas.microsoft.com/office/drawing/2014/main" val="4237335367"/>
                    </a:ext>
                  </a:extLst>
                </a:gridCol>
                <a:gridCol w="1022158">
                  <a:extLst>
                    <a:ext uri="{9D8B030D-6E8A-4147-A177-3AD203B41FA5}">
                      <a16:colId xmlns:a16="http://schemas.microsoft.com/office/drawing/2014/main" val="3583943808"/>
                    </a:ext>
                  </a:extLst>
                </a:gridCol>
              </a:tblGrid>
              <a:tr h="7025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de#1</a:t>
                      </a:r>
                      <a:endParaRPr lang="en-US" sz="1400" b="1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de#2</a:t>
                      </a:r>
                      <a:endParaRPr lang="en-US" sz="1400" b="1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rrelation score</a:t>
                      </a:r>
                      <a:endParaRPr lang="en-US" sz="1400" b="1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11186625"/>
                  </a:ext>
                </a:extLst>
              </a:tr>
              <a:tr h="13603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AF1</a:t>
                      </a:r>
                      <a:endParaRPr lang="en-US" sz="1000" b="1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P3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6</a:t>
                      </a:r>
                      <a:endParaRPr lang="en-US" altLang="zh-CN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35409067"/>
                  </a:ext>
                </a:extLst>
              </a:tr>
              <a:tr h="13603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F4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DIT3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5</a:t>
                      </a:r>
                      <a:endParaRPr lang="en-US" altLang="zh-CN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08456474"/>
                  </a:ext>
                </a:extLst>
              </a:tr>
              <a:tr h="13603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M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NCD2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3</a:t>
                      </a:r>
                      <a:endParaRPr lang="en-US" altLang="zh-CN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20464024"/>
                  </a:ext>
                </a:extLst>
              </a:tr>
              <a:tr h="13603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AF1</a:t>
                      </a:r>
                      <a:endParaRPr lang="en-US" sz="1000" b="1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K1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8</a:t>
                      </a:r>
                      <a:endParaRPr lang="en-US" altLang="zh-CN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632902"/>
                  </a:ext>
                </a:extLst>
              </a:tr>
              <a:tr h="13603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LRC4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LRP6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9</a:t>
                      </a:r>
                      <a:endParaRPr lang="en-US" altLang="zh-CN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60238843"/>
                  </a:ext>
                </a:extLst>
              </a:tr>
              <a:tr h="13603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P3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K4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9</a:t>
                      </a:r>
                      <a:endParaRPr lang="en-US" altLang="zh-CN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00270161"/>
                  </a:ext>
                </a:extLst>
              </a:tr>
              <a:tr h="13603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P2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P3</a:t>
                      </a:r>
                      <a:endParaRPr lang="en-US" sz="1000" b="1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58</a:t>
                      </a:r>
                      <a:endParaRPr lang="en-US" altLang="zh-CN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52842640"/>
                  </a:ext>
                </a:extLst>
              </a:tr>
              <a:tr h="13603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M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YRK2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5</a:t>
                      </a:r>
                      <a:endParaRPr lang="en-US" altLang="zh-CN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57015412"/>
                  </a:ext>
                </a:extLst>
              </a:tr>
              <a:tr h="13603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RT1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FRC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27</a:t>
                      </a:r>
                      <a:endParaRPr lang="en-US" altLang="zh-CN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40799190"/>
                  </a:ext>
                </a:extLst>
              </a:tr>
              <a:tr h="13603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S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L8</a:t>
                      </a:r>
                      <a:endParaRPr lang="en-US" sz="1000" b="1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97</a:t>
                      </a:r>
                      <a:endParaRPr lang="en-US" altLang="zh-CN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28646284"/>
                  </a:ext>
                </a:extLst>
              </a:tr>
              <a:tr h="10883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MF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MAIP1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11</a:t>
                      </a:r>
                      <a:endParaRPr lang="en-US" altLang="zh-CN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69964477"/>
                  </a:ext>
                </a:extLst>
              </a:tr>
              <a:tr h="10883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AF1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P2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06</a:t>
                      </a:r>
                      <a:endParaRPr lang="en-US" altLang="zh-CN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49664964"/>
                  </a:ext>
                </a:extLst>
              </a:tr>
              <a:tr h="10883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P3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PB1</a:t>
                      </a:r>
                      <a:endParaRPr lang="en-US" sz="1000" b="1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82</a:t>
                      </a:r>
                      <a:endParaRPr lang="en-US" altLang="zh-CN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17540783"/>
                  </a:ext>
                </a:extLst>
              </a:tr>
              <a:tr h="10883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C1A5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C7A11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81</a:t>
                      </a:r>
                      <a:endParaRPr lang="en-US" altLang="zh-CN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58069667"/>
                  </a:ext>
                </a:extLst>
              </a:tr>
              <a:tr h="10883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P3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DIT3</a:t>
                      </a:r>
                      <a:endParaRPr lang="en-US" sz="1000" b="1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79</a:t>
                      </a:r>
                      <a:endParaRPr lang="en-US" altLang="zh-CN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48733280"/>
                  </a:ext>
                </a:extLst>
              </a:tr>
              <a:tr h="10883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P2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D1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62</a:t>
                      </a:r>
                      <a:endParaRPr lang="en-US" altLang="zh-CN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53593064"/>
                  </a:ext>
                </a:extLst>
              </a:tr>
              <a:tr h="10883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P3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MAIP1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42</a:t>
                      </a:r>
                      <a:endParaRPr lang="en-US" altLang="zh-CN" sz="1000" b="1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34795650"/>
                  </a:ext>
                </a:extLst>
              </a:tr>
              <a:tr h="10883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AF1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MAIP1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28</a:t>
                      </a:r>
                      <a:endParaRPr lang="en-US" altLang="zh-CN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68352668"/>
                  </a:ext>
                </a:extLst>
              </a:tr>
              <a:tr h="10883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M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P3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82</a:t>
                      </a:r>
                      <a:endParaRPr lang="en-US" altLang="zh-CN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49363952"/>
                  </a:ext>
                </a:extLst>
              </a:tr>
              <a:tr h="10883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K1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P3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9</a:t>
                      </a:r>
                      <a:endParaRPr lang="en-US" altLang="zh-CN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23382805"/>
                  </a:ext>
                </a:extLst>
              </a:tr>
              <a:tr h="10883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K1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MAIP1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22</a:t>
                      </a:r>
                      <a:endParaRPr lang="en-US" altLang="zh-CN" sz="1000" b="1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61996519"/>
                  </a:ext>
                </a:extLst>
              </a:tr>
              <a:tr h="10883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K1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MF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1</a:t>
                      </a:r>
                      <a:endParaRPr lang="en-US" altLang="zh-CN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94692568"/>
                  </a:ext>
                </a:extLst>
              </a:tr>
              <a:tr h="10883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F4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P3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94</a:t>
                      </a:r>
                      <a:endParaRPr lang="en-US" altLang="zh-CN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09764762"/>
                  </a:ext>
                </a:extLst>
              </a:tr>
              <a:tr h="10883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M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P2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83</a:t>
                      </a:r>
                      <a:endParaRPr lang="en-US" altLang="zh-CN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83556982"/>
                  </a:ext>
                </a:extLst>
              </a:tr>
              <a:tr h="10883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AF1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LRC4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8</a:t>
                      </a:r>
                      <a:endParaRPr lang="en-US" altLang="zh-CN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12531239"/>
                  </a:ext>
                </a:extLst>
              </a:tr>
              <a:tr h="10883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AF1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MF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76</a:t>
                      </a:r>
                      <a:endParaRPr lang="en-US" altLang="zh-CN" sz="1000" b="1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04432321"/>
                  </a:ext>
                </a:extLst>
              </a:tr>
              <a:tr h="10883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M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MAIP1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67</a:t>
                      </a:r>
                      <a:endParaRPr lang="en-US" altLang="zh-CN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07137926"/>
                  </a:ext>
                </a:extLst>
              </a:tr>
              <a:tr h="10883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LRC4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D1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61</a:t>
                      </a:r>
                      <a:endParaRPr lang="en-US" altLang="zh-CN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38265589"/>
                  </a:ext>
                </a:extLst>
              </a:tr>
              <a:tr h="10883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P3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FNA5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56</a:t>
                      </a:r>
                      <a:endParaRPr lang="en-US" altLang="zh-CN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81285652"/>
                  </a:ext>
                </a:extLst>
              </a:tr>
              <a:tr h="10883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MF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P3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51</a:t>
                      </a:r>
                      <a:endParaRPr lang="en-US" altLang="zh-CN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40846907"/>
                  </a:ext>
                </a:extLst>
              </a:tr>
              <a:tr h="10883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AF1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CL10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48</a:t>
                      </a:r>
                      <a:endParaRPr lang="en-US" altLang="zh-CN" sz="1000" b="1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46009792"/>
                  </a:ext>
                </a:extLst>
              </a:tr>
              <a:tr h="10883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AF1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M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2</a:t>
                      </a:r>
                      <a:endParaRPr lang="en-US" altLang="zh-CN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88854032"/>
                  </a:ext>
                </a:extLst>
              </a:tr>
              <a:tr h="10883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AF1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PB1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18</a:t>
                      </a:r>
                      <a:endParaRPr lang="en-US" altLang="zh-CN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55695345"/>
                  </a:ext>
                </a:extLst>
              </a:tr>
              <a:tr h="10883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AF1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D1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08</a:t>
                      </a:r>
                      <a:endParaRPr lang="en-US" altLang="zh-CN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97778682"/>
                  </a:ext>
                </a:extLst>
              </a:tr>
              <a:tr h="10883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DIT3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MAIP1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05</a:t>
                      </a:r>
                      <a:endParaRPr lang="en-US" altLang="zh-CN" sz="1000" b="1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2574954"/>
                  </a:ext>
                </a:extLst>
              </a:tr>
              <a:tr h="10883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F4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T1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89</a:t>
                      </a:r>
                      <a:endParaRPr lang="en-US" altLang="zh-CN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50829930"/>
                  </a:ext>
                </a:extLst>
              </a:tr>
              <a:tr h="10883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CL10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LRC4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86</a:t>
                      </a:r>
                      <a:endParaRPr lang="en-US" altLang="zh-CN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96586362"/>
                  </a:ext>
                </a:extLst>
              </a:tr>
              <a:tr h="10883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P3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RT8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8</a:t>
                      </a:r>
                      <a:endParaRPr lang="en-US" altLang="zh-CN" sz="1000" b="1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1655591"/>
                  </a:ext>
                </a:extLst>
              </a:tr>
              <a:tr h="10883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F4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C7A11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75</a:t>
                      </a:r>
                      <a:endParaRPr lang="en-US" altLang="zh-CN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3435574"/>
                  </a:ext>
                </a:extLst>
              </a:tr>
              <a:tr h="10883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CL10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D1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71</a:t>
                      </a:r>
                      <a:endParaRPr lang="en-US" altLang="zh-CN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32726689"/>
                  </a:ext>
                </a:extLst>
              </a:tr>
              <a:tr h="10883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M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2F2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69</a:t>
                      </a:r>
                      <a:endParaRPr lang="en-US" altLang="zh-CN" sz="1000" b="1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87760213"/>
                  </a:ext>
                </a:extLst>
              </a:tr>
              <a:tr h="10883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L8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FRC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69</a:t>
                      </a:r>
                      <a:endParaRPr lang="en-US" altLang="zh-CN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63942370"/>
                  </a:ext>
                </a:extLst>
              </a:tr>
              <a:tr h="10883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K1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P2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62</a:t>
                      </a:r>
                      <a:endParaRPr lang="en-US" altLang="zh-CN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41428911"/>
                  </a:ext>
                </a:extLst>
              </a:tr>
              <a:tr h="10883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P2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MAIP1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6</a:t>
                      </a:r>
                      <a:endParaRPr lang="en-US" altLang="zh-CN" sz="1000" b="1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26502693"/>
                  </a:ext>
                </a:extLst>
              </a:tr>
              <a:tr h="10883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P3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FRC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59</a:t>
                      </a:r>
                      <a:endParaRPr lang="en-US" altLang="zh-CN" sz="1000" b="1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12069272"/>
                  </a:ext>
                </a:extLst>
              </a:tr>
              <a:tr h="10883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CL10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CG1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56</a:t>
                      </a:r>
                      <a:endParaRPr lang="en-US" altLang="zh-CN" sz="1000" b="1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37677632"/>
                  </a:ext>
                </a:extLst>
              </a:tr>
              <a:tr h="10883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P2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LRC4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47</a:t>
                      </a:r>
                      <a:endParaRPr lang="en-US" altLang="zh-CN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1065347"/>
                  </a:ext>
                </a:extLst>
              </a:tr>
              <a:tr h="10883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FRSF12A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FRSF21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45</a:t>
                      </a:r>
                      <a:endParaRPr lang="en-US" altLang="zh-CN" sz="1000" b="1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95316928"/>
                  </a:ext>
                </a:extLst>
              </a:tr>
              <a:tr h="10883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PB1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RT8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38</a:t>
                      </a:r>
                      <a:endParaRPr lang="en-US" altLang="zh-CN" sz="1000" b="1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17028840"/>
                  </a:ext>
                </a:extLst>
              </a:tr>
              <a:tr h="10883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D1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MAIP1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33</a:t>
                      </a:r>
                      <a:endParaRPr lang="en-US" altLang="zh-CN" sz="1000" b="1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1345192"/>
                  </a:ext>
                </a:extLst>
              </a:tr>
              <a:tr h="10883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P3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FRSF21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26</a:t>
                      </a:r>
                      <a:endParaRPr lang="en-US" altLang="zh-CN" sz="1000" b="1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73425494"/>
                  </a:ext>
                </a:extLst>
              </a:tr>
              <a:tr h="10883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CAP31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P3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14</a:t>
                      </a:r>
                      <a:endParaRPr lang="en-US" altLang="zh-CN" sz="1000" b="1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86942119"/>
                  </a:ext>
                </a:extLst>
              </a:tr>
              <a:tr h="10883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FNA5</a:t>
                      </a:r>
                      <a:endParaRPr lang="en-US" sz="1000" b="1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LRC4</a:t>
                      </a:r>
                      <a:endParaRPr lang="en-US" sz="1000" b="1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14</a:t>
                      </a:r>
                      <a:endParaRPr lang="en-US" altLang="zh-CN" sz="1000" b="1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35494076"/>
                  </a:ext>
                </a:extLst>
              </a:tr>
              <a:tr h="10883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AF1</a:t>
                      </a:r>
                      <a:endParaRPr lang="en-US" sz="1000" b="1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DIT3</a:t>
                      </a:r>
                      <a:endParaRPr lang="en-US" sz="1000" b="1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12</a:t>
                      </a:r>
                      <a:endParaRPr lang="en-US" altLang="zh-CN" sz="1000" b="1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732" marR="4732" marT="473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8238959"/>
                  </a:ext>
                </a:extLst>
              </a:tr>
            </a:tbl>
          </a:graphicData>
        </a:graphic>
      </p:graphicFrame>
      <p:sp>
        <p:nvSpPr>
          <p:cNvPr id="6" name="文本框 5">
            <a:extLst>
              <a:ext uri="{FF2B5EF4-FFF2-40B4-BE49-F238E27FC236}">
                <a16:creationId xmlns:a16="http://schemas.microsoft.com/office/drawing/2014/main" id="{BFDA41DD-B7BF-4871-A1B8-5AFF14C8473A}"/>
              </a:ext>
            </a:extLst>
          </p:cNvPr>
          <p:cNvSpPr txBox="1"/>
          <p:nvPr/>
        </p:nvSpPr>
        <p:spPr>
          <a:xfrm>
            <a:off x="570345" y="1750444"/>
            <a:ext cx="2080491" cy="253402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Protein-protein correlation scores of those genes that have p&lt;0.05 correlation with the OS rate.</a:t>
            </a:r>
            <a:endParaRPr lang="zh-CN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5E21F93E-3869-47DA-B491-76B5A5FF5936}"/>
              </a:ext>
            </a:extLst>
          </p:cNvPr>
          <p:cNvSpPr txBox="1"/>
          <p:nvPr/>
        </p:nvSpPr>
        <p:spPr>
          <a:xfrm>
            <a:off x="409805" y="558517"/>
            <a:ext cx="190308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5B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, continued.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52564529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BAFA7131-9800-4FA9-87D2-90765B665CE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454440"/>
            <a:ext cx="6858000" cy="6590714"/>
          </a:xfrm>
          <a:prstGeom prst="rect">
            <a:avLst/>
          </a:prstGeom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090B4E7B-7C01-4801-B7FF-A280995E1FE5}"/>
              </a:ext>
            </a:extLst>
          </p:cNvPr>
          <p:cNvSpPr txBox="1"/>
          <p:nvPr/>
        </p:nvSpPr>
        <p:spPr>
          <a:xfrm>
            <a:off x="409805" y="558517"/>
            <a:ext cx="57900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5C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A0567401-CA0D-46BC-92D8-F0C27D8B7A06}"/>
              </a:ext>
            </a:extLst>
          </p:cNvPr>
          <p:cNvSpPr txBox="1"/>
          <p:nvPr/>
        </p:nvSpPr>
        <p:spPr>
          <a:xfrm>
            <a:off x="305388" y="1081588"/>
            <a:ext cx="641868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rotein-protein correlation of genes between checkpoint molecules and those genes that have p&lt;0.01 correlation with the OS rate.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表格 5">
            <a:extLst>
              <a:ext uri="{FF2B5EF4-FFF2-40B4-BE49-F238E27FC236}">
                <a16:creationId xmlns:a16="http://schemas.microsoft.com/office/drawing/2014/main" id="{A47C6485-1453-4268-9C4A-0A32750489D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05057165"/>
              </p:ext>
            </p:extLst>
          </p:nvPr>
        </p:nvGraphicFramePr>
        <p:xfrm>
          <a:off x="965778" y="8091619"/>
          <a:ext cx="4197350" cy="176022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68358">
                  <a:extLst>
                    <a:ext uri="{9D8B030D-6E8A-4147-A177-3AD203B41FA5}">
                      <a16:colId xmlns:a16="http://schemas.microsoft.com/office/drawing/2014/main" val="1264423257"/>
                    </a:ext>
                  </a:extLst>
                </a:gridCol>
                <a:gridCol w="1268358">
                  <a:extLst>
                    <a:ext uri="{9D8B030D-6E8A-4147-A177-3AD203B41FA5}">
                      <a16:colId xmlns:a16="http://schemas.microsoft.com/office/drawing/2014/main" val="2766498979"/>
                    </a:ext>
                  </a:extLst>
                </a:gridCol>
                <a:gridCol w="1660634">
                  <a:extLst>
                    <a:ext uri="{9D8B030D-6E8A-4147-A177-3AD203B41FA5}">
                      <a16:colId xmlns:a16="http://schemas.microsoft.com/office/drawing/2014/main" val="2283258110"/>
                    </a:ext>
                  </a:extLst>
                </a:gridCol>
              </a:tblGrid>
              <a:tr h="1828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40404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‘-</a:t>
                      </a:r>
                      <a:r>
                        <a:rPr lang="en-US" sz="1400" b="1" i="0" u="none" strike="noStrike" dirty="0" err="1">
                          <a:solidFill>
                            <a:srgbClr val="40404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optosis</a:t>
                      </a:r>
                      <a:r>
                        <a:rPr lang="en-US" sz="1400" b="1" i="0" u="none" strike="noStrike" dirty="0">
                          <a:solidFill>
                            <a:srgbClr val="40404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’ </a:t>
                      </a:r>
                    </a:p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40404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roteins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40404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heckpoint molecules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1" i="0" u="none" strike="noStrike" dirty="0">
                          <a:solidFill>
                            <a:srgbClr val="40404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orrelation </a:t>
                      </a:r>
                    </a:p>
                    <a:p>
                      <a:pPr algn="ctr" fontAlgn="ctr"/>
                      <a:r>
                        <a:rPr lang="en-US" altLang="zh-CN" sz="1400" b="1" i="0" u="none" strike="noStrike" dirty="0">
                          <a:solidFill>
                            <a:srgbClr val="40404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score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96595586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CL10</a:t>
                      </a:r>
                      <a:endParaRPr lang="en-US" sz="1400" b="0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28</a:t>
                      </a:r>
                      <a:endParaRPr lang="en-US" sz="1400" b="0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59</a:t>
                      </a:r>
                      <a:endParaRPr lang="en-US" altLang="zh-CN" sz="1400" b="0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78212328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CL10</a:t>
                      </a:r>
                      <a:endParaRPr lang="en-US" sz="1400" b="0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LA4</a:t>
                      </a:r>
                      <a:endParaRPr lang="en-US" sz="1400" b="0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19</a:t>
                      </a:r>
                      <a:endParaRPr lang="en-US" altLang="zh-CN" sz="1400" b="0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98903289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CL10</a:t>
                      </a:r>
                      <a:endParaRPr lang="en-US" sz="1400" b="0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0</a:t>
                      </a:r>
                      <a:endParaRPr lang="en-US" sz="1400" b="0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12</a:t>
                      </a:r>
                      <a:endParaRPr lang="en-US" altLang="zh-CN" sz="1400" b="0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442592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FRC</a:t>
                      </a:r>
                      <a:endParaRPr lang="en-US" sz="1400" b="0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28</a:t>
                      </a:r>
                      <a:endParaRPr lang="en-US" sz="1400" b="0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03</a:t>
                      </a:r>
                      <a:endParaRPr lang="en-US" altLang="zh-CN" sz="1400" b="0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63059318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FRC</a:t>
                      </a:r>
                      <a:endParaRPr lang="en-US" sz="1400" b="0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0</a:t>
                      </a:r>
                      <a:endParaRPr lang="en-US" sz="1400" b="0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57</a:t>
                      </a:r>
                      <a:endParaRPr lang="en-US" altLang="zh-CN" sz="1400" b="0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5727889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FRC</a:t>
                      </a:r>
                      <a:endParaRPr lang="en-US" sz="1400" b="0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LA4</a:t>
                      </a:r>
                      <a:endParaRPr lang="en-US" sz="1400" b="0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29</a:t>
                      </a:r>
                      <a:endParaRPr lang="en-US" altLang="zh-CN" sz="1400" b="0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6885437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89372724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026FBCD4-2398-4E29-BD7F-12B3263BFDE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369473"/>
            <a:ext cx="6858000" cy="8164572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EC16A4BB-125A-4440-AFD7-23686DCF2990}"/>
              </a:ext>
            </a:extLst>
          </p:cNvPr>
          <p:cNvSpPr txBox="1"/>
          <p:nvPr/>
        </p:nvSpPr>
        <p:spPr>
          <a:xfrm>
            <a:off x="409805" y="392262"/>
            <a:ext cx="57900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5D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9F847F08-270A-4053-97D1-7E137C6C0B9A}"/>
              </a:ext>
            </a:extLst>
          </p:cNvPr>
          <p:cNvSpPr txBox="1"/>
          <p:nvPr/>
        </p:nvSpPr>
        <p:spPr>
          <a:xfrm>
            <a:off x="305388" y="906099"/>
            <a:ext cx="641868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rotein-protein correlation of genes between checkpoint molecules and those genes that have p&lt;0.05 correlation with the OS rate.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73784403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6D5BD1E4-7B2F-4F13-BF1B-395F3D1512CE}"/>
              </a:ext>
            </a:extLst>
          </p:cNvPr>
          <p:cNvSpPr txBox="1"/>
          <p:nvPr/>
        </p:nvSpPr>
        <p:spPr>
          <a:xfrm>
            <a:off x="305388" y="923065"/>
            <a:ext cx="190308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5D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, continued.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表格 5">
            <a:extLst>
              <a:ext uri="{FF2B5EF4-FFF2-40B4-BE49-F238E27FC236}">
                <a16:creationId xmlns:a16="http://schemas.microsoft.com/office/drawing/2014/main" id="{DACA2579-B41B-45F1-8294-E6069B01119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33178887"/>
              </p:ext>
            </p:extLst>
          </p:nvPr>
        </p:nvGraphicFramePr>
        <p:xfrm>
          <a:off x="815686" y="2365663"/>
          <a:ext cx="5304228" cy="507492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02852">
                  <a:extLst>
                    <a:ext uri="{9D8B030D-6E8A-4147-A177-3AD203B41FA5}">
                      <a16:colId xmlns:a16="http://schemas.microsoft.com/office/drawing/2014/main" val="3456574131"/>
                    </a:ext>
                  </a:extLst>
                </a:gridCol>
                <a:gridCol w="1080452">
                  <a:extLst>
                    <a:ext uri="{9D8B030D-6E8A-4147-A177-3AD203B41FA5}">
                      <a16:colId xmlns:a16="http://schemas.microsoft.com/office/drawing/2014/main" val="3800267903"/>
                    </a:ext>
                  </a:extLst>
                </a:gridCol>
                <a:gridCol w="1109036">
                  <a:extLst>
                    <a:ext uri="{9D8B030D-6E8A-4147-A177-3AD203B41FA5}">
                      <a16:colId xmlns:a16="http://schemas.microsoft.com/office/drawing/2014/main" val="1334521998"/>
                    </a:ext>
                  </a:extLst>
                </a:gridCol>
                <a:gridCol w="2111888">
                  <a:extLst>
                    <a:ext uri="{9D8B030D-6E8A-4147-A177-3AD203B41FA5}">
                      <a16:colId xmlns:a16="http://schemas.microsoft.com/office/drawing/2014/main" val="2065350310"/>
                    </a:ext>
                  </a:extLst>
                </a:gridCol>
              </a:tblGrid>
              <a:tr h="198120">
                <a:tc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solidFill>
                          <a:srgbClr val="404040"/>
                        </a:solidFill>
                        <a:effectLst/>
                        <a:latin typeface="Roboto" panose="02000000000000000000" pitchFamily="2" charset="0"/>
                        <a:ea typeface="等线" panose="02010600030101010101" pitchFamily="2" charset="-122"/>
                      </a:endParaRPr>
                    </a:p>
                  </a:txBody>
                  <a:tcPr marL="7620" marR="7620" marT="762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40404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‘-</a:t>
                      </a:r>
                      <a:r>
                        <a:rPr lang="en-US" sz="1400" b="1" i="0" u="none" strike="noStrike" dirty="0" err="1">
                          <a:solidFill>
                            <a:srgbClr val="40404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optosis</a:t>
                      </a:r>
                      <a:r>
                        <a:rPr lang="en-US" sz="1400" b="1" i="0" u="none" strike="noStrike" dirty="0">
                          <a:solidFill>
                            <a:srgbClr val="40404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’ </a:t>
                      </a:r>
                    </a:p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40404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roteins</a:t>
                      </a:r>
                    </a:p>
                  </a:txBody>
                  <a:tcPr marL="7620" marR="7620" marT="762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40404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heckpoint molecules</a:t>
                      </a:r>
                    </a:p>
                  </a:txBody>
                  <a:tcPr marL="7620" marR="7620" marT="762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1" i="0" u="none" strike="noStrike" dirty="0">
                          <a:solidFill>
                            <a:srgbClr val="40404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orrelation </a:t>
                      </a:r>
                    </a:p>
                    <a:p>
                      <a:pPr algn="ctr" fontAlgn="ctr"/>
                      <a:r>
                        <a:rPr lang="en-US" altLang="zh-CN" sz="1400" b="1" i="0" u="none" strike="noStrike" dirty="0">
                          <a:solidFill>
                            <a:srgbClr val="40404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score</a:t>
                      </a:r>
                    </a:p>
                  </a:txBody>
                  <a:tcPr marL="7620" marR="7620" marT="762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508510"/>
                  </a:ext>
                </a:extLst>
              </a:tr>
              <a:tr h="198120">
                <a:tc rowSpan="10">
                  <a:txBody>
                    <a:bodyPr/>
                    <a:lstStyle/>
                    <a:p>
                      <a:pPr algn="l" fontAlgn="ctr"/>
                      <a:r>
                        <a:rPr lang="en-US" sz="1400" b="1" i="0" u="none" strike="noStrike" dirty="0">
                          <a:solidFill>
                            <a:srgbClr val="40404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poptosis</a:t>
                      </a:r>
                    </a:p>
                  </a:txBody>
                  <a:tcPr marL="7620" marR="7620" marT="7620" marB="0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40404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SIVA1</a:t>
                      </a:r>
                    </a:p>
                  </a:txBody>
                  <a:tcPr marL="7620" marR="7620" marT="762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40404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D27</a:t>
                      </a:r>
                    </a:p>
                  </a:txBody>
                  <a:tcPr marL="7620" marR="7620" marT="762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40404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979</a:t>
                      </a:r>
                    </a:p>
                  </a:txBody>
                  <a:tcPr marL="7620" marR="7620" marT="762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40518987"/>
                  </a:ext>
                </a:extLst>
              </a:tr>
              <a:tr h="198120">
                <a:tc vMerge="1"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solidFill>
                          <a:srgbClr val="404040"/>
                        </a:solidFill>
                        <a:effectLst/>
                        <a:latin typeface="Roboto" panose="02000000000000000000" pitchFamily="2" charset="0"/>
                        <a:ea typeface="等线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40404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NFRSF12A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40404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D4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40404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745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77722330"/>
                  </a:ext>
                </a:extLst>
              </a:tr>
              <a:tr h="198120">
                <a:tc vMerge="1"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solidFill>
                          <a:srgbClr val="404040"/>
                        </a:solidFill>
                        <a:effectLst/>
                        <a:latin typeface="Roboto" panose="02000000000000000000" pitchFamily="2" charset="0"/>
                        <a:ea typeface="等线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40404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PP2R1B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40404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TLA4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40404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6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79104388"/>
                  </a:ext>
                </a:extLst>
              </a:tr>
              <a:tr h="198120">
                <a:tc vMerge="1"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solidFill>
                          <a:srgbClr val="404040"/>
                        </a:solidFill>
                        <a:effectLst/>
                        <a:latin typeface="Roboto" panose="02000000000000000000" pitchFamily="2" charset="0"/>
                        <a:ea typeface="等线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40404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CL1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40404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D28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40404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559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08516576"/>
                  </a:ext>
                </a:extLst>
              </a:tr>
              <a:tr h="198120">
                <a:tc vMerge="1"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solidFill>
                          <a:srgbClr val="404040"/>
                        </a:solidFill>
                        <a:effectLst/>
                        <a:latin typeface="Roboto" panose="02000000000000000000" pitchFamily="2" charset="0"/>
                        <a:ea typeface="等线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40404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TM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40404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D274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40404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53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37543909"/>
                  </a:ext>
                </a:extLst>
              </a:tr>
              <a:tr h="198120">
                <a:tc vMerge="1"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solidFill>
                          <a:srgbClr val="404040"/>
                        </a:solidFill>
                        <a:effectLst/>
                        <a:latin typeface="Roboto" panose="02000000000000000000" pitchFamily="2" charset="0"/>
                        <a:ea typeface="等线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40404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CL1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40404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TLA4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40404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519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35455660"/>
                  </a:ext>
                </a:extLst>
              </a:tr>
              <a:tr h="198120">
                <a:tc vMerge="1"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solidFill>
                          <a:srgbClr val="404040"/>
                        </a:solidFill>
                        <a:effectLst/>
                        <a:latin typeface="Roboto" panose="02000000000000000000" pitchFamily="2" charset="0"/>
                        <a:ea typeface="等线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40404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DDIT3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40404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D28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40404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508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53429085"/>
                  </a:ext>
                </a:extLst>
              </a:tr>
              <a:tr h="198120">
                <a:tc vMerge="1"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solidFill>
                          <a:srgbClr val="404040"/>
                        </a:solidFill>
                        <a:effectLst/>
                        <a:latin typeface="Roboto" panose="02000000000000000000" pitchFamily="2" charset="0"/>
                        <a:ea typeface="等线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40404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DDIT3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40404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TLA4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40404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468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08066243"/>
                  </a:ext>
                </a:extLst>
              </a:tr>
              <a:tr h="198120">
                <a:tc vMerge="1"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solidFill>
                          <a:srgbClr val="404040"/>
                        </a:solidFill>
                        <a:effectLst/>
                        <a:latin typeface="Roboto" panose="02000000000000000000" pitchFamily="2" charset="0"/>
                        <a:ea typeface="等线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40404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DDIT3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40404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D4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40404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44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66897032"/>
                  </a:ext>
                </a:extLst>
              </a:tr>
              <a:tr h="198120">
                <a:tc vMerge="1"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solidFill>
                          <a:srgbClr val="404040"/>
                        </a:solidFill>
                        <a:effectLst/>
                        <a:latin typeface="Roboto" panose="02000000000000000000" pitchFamily="2" charset="0"/>
                        <a:ea typeface="等线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40404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CL10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40404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D40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40404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412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97051802"/>
                  </a:ext>
                </a:extLst>
              </a:tr>
              <a:tr h="198120">
                <a:tc rowSpan="4">
                  <a:txBody>
                    <a:bodyPr/>
                    <a:lstStyle/>
                    <a:p>
                      <a:pPr algn="l" fontAlgn="ctr"/>
                      <a:r>
                        <a:rPr lang="en-US" sz="1400" b="1" i="0" u="none" strike="noStrike" dirty="0">
                          <a:solidFill>
                            <a:srgbClr val="40404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Ferroptosis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FRC</a:t>
                      </a:r>
                      <a:endParaRPr lang="en-US" sz="1400" b="0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LA4</a:t>
                      </a:r>
                      <a:endParaRPr lang="en-US" sz="1400" b="0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29</a:t>
                      </a:r>
                      <a:endParaRPr lang="en-US" altLang="zh-CN" sz="1400" b="0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6494857"/>
                  </a:ext>
                </a:extLst>
              </a:tr>
              <a:tr h="198120">
                <a:tc vMerge="1"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solidFill>
                          <a:srgbClr val="404040"/>
                        </a:solidFill>
                        <a:effectLst/>
                        <a:latin typeface="Roboto" panose="02000000000000000000" pitchFamily="2" charset="0"/>
                        <a:ea typeface="等线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FRC</a:t>
                      </a:r>
                      <a:endParaRPr lang="en-US" sz="1400" b="0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28</a:t>
                      </a:r>
                      <a:endParaRPr lang="en-US" sz="1400" b="0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03</a:t>
                      </a:r>
                      <a:endParaRPr lang="en-US" altLang="zh-CN" sz="1400" b="0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77692972"/>
                  </a:ext>
                </a:extLst>
              </a:tr>
              <a:tr h="198120">
                <a:tc vMerge="1"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solidFill>
                          <a:srgbClr val="404040"/>
                        </a:solidFill>
                        <a:effectLst/>
                        <a:latin typeface="Roboto" panose="02000000000000000000" pitchFamily="2" charset="0"/>
                        <a:ea typeface="等线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FRC</a:t>
                      </a:r>
                      <a:endParaRPr lang="en-US" sz="1400" b="0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27</a:t>
                      </a:r>
                      <a:endParaRPr lang="en-US" sz="1400" b="0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59</a:t>
                      </a:r>
                      <a:endParaRPr lang="en-US" altLang="zh-CN" sz="1400" b="0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54182518"/>
                  </a:ext>
                </a:extLst>
              </a:tr>
              <a:tr h="198120">
                <a:tc vMerge="1"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solidFill>
                          <a:srgbClr val="404040"/>
                        </a:solidFill>
                        <a:effectLst/>
                        <a:latin typeface="Roboto" panose="02000000000000000000" pitchFamily="2" charset="0"/>
                        <a:ea typeface="等线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FRC</a:t>
                      </a:r>
                      <a:endParaRPr lang="en-US" sz="1400" b="0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0</a:t>
                      </a:r>
                      <a:endParaRPr lang="en-US" sz="1400" b="0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57</a:t>
                      </a:r>
                      <a:endParaRPr lang="en-US" altLang="zh-CN" sz="1400" b="0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88431582"/>
                  </a:ext>
                </a:extLst>
              </a:tr>
              <a:tr h="198120">
                <a:tc rowSpan="7">
                  <a:txBody>
                    <a:bodyPr/>
                    <a:lstStyle/>
                    <a:p>
                      <a:pPr algn="l" fontAlgn="ctr"/>
                      <a:r>
                        <a:rPr lang="en-US" sz="1400" b="1" i="0" u="none" strike="noStrike" dirty="0" err="1">
                          <a:solidFill>
                            <a:srgbClr val="40404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yroptosis</a:t>
                      </a:r>
                      <a:endParaRPr lang="en-US" sz="1400" b="1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CG1</a:t>
                      </a:r>
                      <a:endParaRPr lang="en-US" sz="1400" b="0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28</a:t>
                      </a:r>
                      <a:endParaRPr lang="en-US" sz="1400" b="0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09</a:t>
                      </a:r>
                      <a:endParaRPr lang="en-US" altLang="zh-CN" sz="1400" b="0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62857852"/>
                  </a:ext>
                </a:extLst>
              </a:tr>
              <a:tr h="198120">
                <a:tc vMerge="1"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solidFill>
                          <a:srgbClr val="404040"/>
                        </a:solidFill>
                        <a:effectLst/>
                        <a:latin typeface="Roboto" panose="02000000000000000000" pitchFamily="2" charset="0"/>
                        <a:ea typeface="等线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CG1</a:t>
                      </a:r>
                      <a:endParaRPr lang="en-US" sz="1400" b="0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LA4</a:t>
                      </a:r>
                      <a:endParaRPr lang="en-US" sz="1400" b="0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1</a:t>
                      </a:r>
                      <a:endParaRPr lang="en-US" altLang="zh-CN" sz="1400" b="0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9446278"/>
                  </a:ext>
                </a:extLst>
              </a:tr>
              <a:tr h="198120">
                <a:tc vMerge="1"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 err="1">
                          <a:solidFill>
                            <a:srgbClr val="404040"/>
                          </a:solidFill>
                          <a:effectLst/>
                          <a:latin typeface="Roboto" panose="02000000000000000000" pitchFamily="2" charset="0"/>
                          <a:ea typeface="等线" panose="02010600030101010101" pitchFamily="2" charset="-122"/>
                        </a:rPr>
                        <a:t>pyroptosis</a:t>
                      </a:r>
                      <a:endParaRPr lang="en-US" sz="1200" b="0" i="0" u="none" strike="noStrike" dirty="0">
                        <a:solidFill>
                          <a:srgbClr val="404040"/>
                        </a:solidFill>
                        <a:effectLst/>
                        <a:latin typeface="Roboto" panose="02000000000000000000" pitchFamily="2" charset="0"/>
                        <a:ea typeface="等线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P3</a:t>
                      </a:r>
                      <a:endParaRPr lang="en-US" sz="1400" b="0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0</a:t>
                      </a:r>
                      <a:endParaRPr lang="en-US" sz="1400" b="0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7</a:t>
                      </a:r>
                      <a:endParaRPr lang="en-US" altLang="zh-CN" sz="1400" b="0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48443010"/>
                  </a:ext>
                </a:extLst>
              </a:tr>
              <a:tr h="198120">
                <a:tc vMerge="1"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solidFill>
                          <a:srgbClr val="404040"/>
                        </a:solidFill>
                        <a:effectLst/>
                        <a:latin typeface="Roboto" panose="02000000000000000000" pitchFamily="2" charset="0"/>
                        <a:ea typeface="等线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P3</a:t>
                      </a:r>
                      <a:endParaRPr lang="en-US" sz="1400" b="0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LA4</a:t>
                      </a:r>
                      <a:endParaRPr lang="en-US" sz="1400" b="0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69</a:t>
                      </a:r>
                      <a:endParaRPr lang="en-US" altLang="zh-CN" sz="1400" b="0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76211460"/>
                  </a:ext>
                </a:extLst>
              </a:tr>
              <a:tr h="198120">
                <a:tc vMerge="1">
                  <a:txBody>
                    <a:bodyPr/>
                    <a:lstStyle/>
                    <a:p>
                      <a:pPr algn="l" fontAlgn="ctr"/>
                      <a:endParaRPr lang="en-US" sz="1200" b="0" i="0" u="none" strike="noStrike">
                        <a:solidFill>
                          <a:srgbClr val="404040"/>
                        </a:solidFill>
                        <a:effectLst/>
                        <a:latin typeface="Roboto" panose="02000000000000000000" pitchFamily="2" charset="0"/>
                        <a:ea typeface="等线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P3</a:t>
                      </a:r>
                      <a:endParaRPr lang="en-US" sz="1400" b="0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27</a:t>
                      </a:r>
                      <a:endParaRPr lang="en-US" sz="1400" b="0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32</a:t>
                      </a:r>
                      <a:endParaRPr lang="en-US" altLang="zh-CN" sz="1400" b="0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50022634"/>
                  </a:ext>
                </a:extLst>
              </a:tr>
              <a:tr h="198120">
                <a:tc vMerge="1"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solidFill>
                          <a:srgbClr val="404040"/>
                        </a:solidFill>
                        <a:effectLst/>
                        <a:latin typeface="Roboto" panose="02000000000000000000" pitchFamily="2" charset="0"/>
                        <a:ea typeface="等线" panose="02010600030101010101" pitchFamily="2" charset="-122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P3</a:t>
                      </a:r>
                      <a:endParaRPr lang="en-US" sz="1400" b="0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274</a:t>
                      </a:r>
                      <a:endParaRPr lang="en-US" sz="1400" b="0" i="0" u="none" strike="noStrike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27</a:t>
                      </a:r>
                      <a:endParaRPr lang="en-US" altLang="zh-CN" sz="1400" b="0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90450503"/>
                  </a:ext>
                </a:extLst>
              </a:tr>
              <a:tr h="198120">
                <a:tc vMerge="1"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solidFill>
                          <a:srgbClr val="404040"/>
                        </a:solidFill>
                        <a:effectLst/>
                        <a:latin typeface="Roboto" panose="02000000000000000000" pitchFamily="2" charset="0"/>
                        <a:ea typeface="等线" panose="02010600030101010101" pitchFamily="2" charset="-122"/>
                      </a:endParaRPr>
                    </a:p>
                  </a:txBody>
                  <a:tcPr marL="7620" marR="7620" marT="762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P3</a:t>
                      </a:r>
                      <a:endParaRPr lang="en-US" sz="1400" b="0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28</a:t>
                      </a:r>
                      <a:endParaRPr lang="en-US" sz="1400" b="0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24</a:t>
                      </a:r>
                      <a:endParaRPr lang="en-US" altLang="zh-CN" sz="1400" b="0" i="0" u="none" strike="noStrike" dirty="0">
                        <a:solidFill>
                          <a:srgbClr val="40404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64837719"/>
                  </a:ext>
                </a:extLst>
              </a:tr>
            </a:tbl>
          </a:graphicData>
        </a:graphic>
      </p:graphicFrame>
      <p:sp>
        <p:nvSpPr>
          <p:cNvPr id="7" name="文本框 6">
            <a:extLst>
              <a:ext uri="{FF2B5EF4-FFF2-40B4-BE49-F238E27FC236}">
                <a16:creationId xmlns:a16="http://schemas.microsoft.com/office/drawing/2014/main" id="{480AB11B-D23A-4786-9E09-391FAA62D6DE}"/>
              </a:ext>
            </a:extLst>
          </p:cNvPr>
          <p:cNvSpPr txBox="1"/>
          <p:nvPr/>
        </p:nvSpPr>
        <p:spPr>
          <a:xfrm>
            <a:off x="305388" y="1691189"/>
            <a:ext cx="641868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rotein-protein correlation score of genes between checkpoint molecules and those genes that have p&lt;0.05 correlation with the OS rate.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45732316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29CCCE41-56FD-44BF-AC12-EDB09BB8878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414" r="4624" b="4465"/>
          <a:stretch/>
        </p:blipFill>
        <p:spPr>
          <a:xfrm>
            <a:off x="80058" y="3227732"/>
            <a:ext cx="3348942" cy="2016000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79E1912E-38E2-4F3B-987C-B27DE3B58E43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798" r="6476" b="5717"/>
          <a:stretch/>
        </p:blipFill>
        <p:spPr>
          <a:xfrm>
            <a:off x="3430381" y="3227732"/>
            <a:ext cx="3347561" cy="2016000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210BD5B9-A631-4671-9F6A-4B0BFCD156D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000" y="5386733"/>
            <a:ext cx="6480000" cy="4320000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AD50453F-A7C9-49CB-8892-683F2AB990C4}"/>
              </a:ext>
            </a:extLst>
          </p:cNvPr>
          <p:cNvSpPr txBox="1"/>
          <p:nvPr/>
        </p:nvSpPr>
        <p:spPr>
          <a:xfrm>
            <a:off x="383998" y="549256"/>
            <a:ext cx="5613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5E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内容占位符 2">
            <a:extLst>
              <a:ext uri="{FF2B5EF4-FFF2-40B4-BE49-F238E27FC236}">
                <a16:creationId xmlns:a16="http://schemas.microsoft.com/office/drawing/2014/main" id="{9C756AF2-183E-4813-A995-53BBB6FF440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89000" y="1010921"/>
            <a:ext cx="6669000" cy="2016000"/>
          </a:xfrm>
        </p:spPr>
        <p:txBody>
          <a:bodyPr>
            <a:noAutofit/>
          </a:bodyPr>
          <a:lstStyle/>
          <a:p>
            <a:pPr marL="0" indent="0">
              <a:lnSpc>
                <a:spcPct val="150000"/>
              </a:lnSpc>
              <a:buNone/>
            </a:pPr>
            <a:r>
              <a:rPr lang="en-GB" altLang="zh-CN" sz="14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he prognostic signature model was obtained based on 15 ‘-</a:t>
            </a:r>
            <a:r>
              <a:rPr lang="en-GB" altLang="zh-CN" sz="14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optosis</a:t>
            </a:r>
            <a:r>
              <a:rPr lang="en-GB" altLang="zh-CN" sz="14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’ genes with p</a:t>
            </a:r>
            <a:r>
              <a:rPr lang="zh-CN" altLang="zh-CN" sz="14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≤</a:t>
            </a:r>
            <a:r>
              <a:rPr lang="en-GB" altLang="zh-CN" sz="14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0.01 correlation with OS and the LASSO Cox regression algorithm. The obtained </a:t>
            </a:r>
            <a:r>
              <a:rPr lang="el-GR" altLang="zh-CN" sz="14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λ</a:t>
            </a:r>
            <a:r>
              <a:rPr lang="en-US" altLang="zh-CN" sz="1400" i="0" baseline="-25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min</a:t>
            </a:r>
            <a:r>
              <a:rPr lang="en-US" altLang="zh-CN" sz="1400" i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=0.0163.The obtained </a:t>
            </a:r>
            <a:r>
              <a:rPr lang="en-US" altLang="zh-CN" sz="1400" i="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Riskscore</a:t>
            </a:r>
            <a:r>
              <a:rPr lang="en-US" altLang="zh-CN" sz="1400" i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  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=(0.1147)*E2F2+(0.1758)*SNW1+ (0.0781)*GSDME+(-0.2054)*NLRP6 + (-0.1248)*NOD1+(0.3168)*CARS1+ (0.02)*RPL8+(0.1567)*SLC7A11 + (0.0408)*SLC1A5</a:t>
            </a:r>
            <a:r>
              <a:rPr lang="en-US" altLang="zh-CN" sz="1400" i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. The correlation between </a:t>
            </a:r>
            <a:r>
              <a:rPr lang="en-US" altLang="zh-CN" sz="1400" i="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Riskscore</a:t>
            </a:r>
            <a:r>
              <a:rPr lang="en-US" altLang="zh-CN" sz="1400" i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 and overall survival/status is shown in the middle right graph.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528916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AFB25DA1-A7BE-4452-99A1-6166527EEA4B}"/>
              </a:ext>
            </a:extLst>
          </p:cNvPr>
          <p:cNvSpPr txBox="1"/>
          <p:nvPr/>
        </p:nvSpPr>
        <p:spPr>
          <a:xfrm>
            <a:off x="277876" y="403950"/>
            <a:ext cx="64472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b="1" dirty="0">
                <a:latin typeface="Arial" panose="020B0604020202020204" pitchFamily="34" charset="0"/>
                <a:cs typeface="Arial" panose="020B0604020202020204" pitchFamily="34" charset="0"/>
              </a:rPr>
              <a:t>2B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D07E2E5D-D9AB-4247-8229-2CF3765FB13E}"/>
              </a:ext>
            </a:extLst>
          </p:cNvPr>
          <p:cNvSpPr txBox="1"/>
          <p:nvPr/>
        </p:nvSpPr>
        <p:spPr>
          <a:xfrm>
            <a:off x="765247" y="665560"/>
            <a:ext cx="6092753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orrelation analysis between 22 apoptosis marker genes that have lower correlation with overall survival rate (P&lt;0.05) and checkpoint molecules (includes stimulatory and inhibitory) or immune cells.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FBC46F45-E6BA-41DC-826D-C42054FCAF6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602259"/>
            <a:ext cx="6858000" cy="4697951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13174315-720C-466C-A9B2-44A64C504C1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289577"/>
            <a:ext cx="6858000" cy="34844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3907495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图片 11">
            <a:extLst>
              <a:ext uri="{FF2B5EF4-FFF2-40B4-BE49-F238E27FC236}">
                <a16:creationId xmlns:a16="http://schemas.microsoft.com/office/drawing/2014/main" id="{1996984A-66CE-4DC6-880A-A7D2EEE7933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5415" y="1581210"/>
            <a:ext cx="4320000" cy="2160000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3662E61B-6CEF-49A2-9666-00B90084444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92389" y="1581210"/>
            <a:ext cx="2177391" cy="2160000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CFF7A7E7-EAD2-4C21-A418-233C9B28532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1507" y="3720537"/>
            <a:ext cx="2648700" cy="3240000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69C018DF-83E7-4CC0-9121-AA58D3B50A78}"/>
              </a:ext>
            </a:extLst>
          </p:cNvPr>
          <p:cNvSpPr txBox="1"/>
          <p:nvPr/>
        </p:nvSpPr>
        <p:spPr>
          <a:xfrm>
            <a:off x="108809" y="96475"/>
            <a:ext cx="64472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b="1" dirty="0">
                <a:latin typeface="Arial" panose="020B0604020202020204" pitchFamily="34" charset="0"/>
                <a:cs typeface="Arial" panose="020B0604020202020204" pitchFamily="34" charset="0"/>
              </a:rPr>
              <a:t>2C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表格 2">
            <a:extLst>
              <a:ext uri="{FF2B5EF4-FFF2-40B4-BE49-F238E27FC236}">
                <a16:creationId xmlns:a16="http://schemas.microsoft.com/office/drawing/2014/main" id="{40DA6119-25A0-4091-A893-802B2D0D9DE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13110622"/>
              </p:ext>
            </p:extLst>
          </p:nvPr>
        </p:nvGraphicFramePr>
        <p:xfrm>
          <a:off x="228765" y="7400702"/>
          <a:ext cx="6300169" cy="2209800"/>
        </p:xfrm>
        <a:graphic>
          <a:graphicData uri="http://schemas.openxmlformats.org/drawingml/2006/table">
            <a:tbl>
              <a:tblPr/>
              <a:tblGrid>
                <a:gridCol w="1215838">
                  <a:extLst>
                    <a:ext uri="{9D8B030D-6E8A-4147-A177-3AD203B41FA5}">
                      <a16:colId xmlns:a16="http://schemas.microsoft.com/office/drawing/2014/main" val="3021234922"/>
                    </a:ext>
                  </a:extLst>
                </a:gridCol>
                <a:gridCol w="1711390">
                  <a:extLst>
                    <a:ext uri="{9D8B030D-6E8A-4147-A177-3AD203B41FA5}">
                      <a16:colId xmlns:a16="http://schemas.microsoft.com/office/drawing/2014/main" val="1407910450"/>
                    </a:ext>
                  </a:extLst>
                </a:gridCol>
                <a:gridCol w="1215838">
                  <a:extLst>
                    <a:ext uri="{9D8B030D-6E8A-4147-A177-3AD203B41FA5}">
                      <a16:colId xmlns:a16="http://schemas.microsoft.com/office/drawing/2014/main" val="195685125"/>
                    </a:ext>
                  </a:extLst>
                </a:gridCol>
                <a:gridCol w="1215838">
                  <a:extLst>
                    <a:ext uri="{9D8B030D-6E8A-4147-A177-3AD203B41FA5}">
                      <a16:colId xmlns:a16="http://schemas.microsoft.com/office/drawing/2014/main" val="2985991925"/>
                    </a:ext>
                  </a:extLst>
                </a:gridCol>
                <a:gridCol w="941265">
                  <a:extLst>
                    <a:ext uri="{9D8B030D-6E8A-4147-A177-3AD203B41FA5}">
                      <a16:colId xmlns:a16="http://schemas.microsoft.com/office/drawing/2014/main" val="2900404367"/>
                    </a:ext>
                  </a:extLst>
                </a:gridCol>
              </a:tblGrid>
              <a:tr h="175260"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endParaRPr lang="zh-CN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Describe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1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2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3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37175921"/>
                  </a:ext>
                </a:extLst>
              </a:tr>
              <a:tr h="175260">
                <a:tc rowSpan="2"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Status</a:t>
                      </a:r>
                    </a:p>
                  </a:txBody>
                  <a:tcPr marL="7620" marR="7620" marT="762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live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51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7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63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00749453"/>
                  </a:ext>
                </a:extLst>
              </a:tr>
              <a:tr h="175260">
                <a:tc vMerge="1"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Dead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80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7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3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478729"/>
                  </a:ext>
                </a:extLst>
              </a:tr>
              <a:tr h="175260">
                <a:tc rowSpan="2"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ge</a:t>
                      </a:r>
                    </a:p>
                  </a:txBody>
                  <a:tcPr marL="7620" marR="7620" marT="762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Mean (SD)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59.6 (13.5)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55.8 (16.8)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60.7 (11.6)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63177889"/>
                  </a:ext>
                </a:extLst>
              </a:tr>
              <a:tr h="175260">
                <a:tc vMerge="1"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Median [MIN, MAX]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61 [16,85]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59.5 [17,85]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62 [29,90]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43349076"/>
                  </a:ext>
                </a:extLst>
              </a:tr>
              <a:tr h="175260">
                <a:tc rowSpan="2"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ender</a:t>
                      </a:r>
                    </a:p>
                  </a:txBody>
                  <a:tcPr marL="7620" marR="7620" marT="762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FEMALE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69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2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0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6862045"/>
                  </a:ext>
                </a:extLst>
              </a:tr>
              <a:tr h="175260">
                <a:tc vMerge="1"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MALE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62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2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66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6728667"/>
                  </a:ext>
                </a:extLst>
              </a:tr>
              <a:tr h="175260">
                <a:tc rowSpan="3"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TNM_stage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I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11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6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44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919899397"/>
                  </a:ext>
                </a:extLst>
              </a:tr>
              <a:tr h="175260">
                <a:tc vMerge="1"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II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52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9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5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4055105"/>
                  </a:ext>
                </a:extLst>
              </a:tr>
              <a:tr h="175260">
                <a:tc vMerge="1">
                  <a:txBody>
                    <a:bodyPr/>
                    <a:lstStyle/>
                    <a:p>
                      <a:pPr algn="l" fontAlgn="ctr"/>
                      <a:endParaRPr lang="zh-CN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III-IV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56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6</a:t>
                      </a:r>
                      <a:endParaRPr lang="zh-CN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8</a:t>
                      </a:r>
                      <a:endParaRPr lang="zh-CN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1248075"/>
                  </a:ext>
                </a:extLst>
              </a:tr>
            </a:tbl>
          </a:graphicData>
        </a:graphic>
      </p:graphicFrame>
      <p:sp>
        <p:nvSpPr>
          <p:cNvPr id="5" name="文本框 4">
            <a:extLst>
              <a:ext uri="{FF2B5EF4-FFF2-40B4-BE49-F238E27FC236}">
                <a16:creationId xmlns:a16="http://schemas.microsoft.com/office/drawing/2014/main" id="{0B1F9226-24B2-4A48-BC04-2C4AD2E7F2E8}"/>
              </a:ext>
            </a:extLst>
          </p:cNvPr>
          <p:cNvSpPr txBox="1"/>
          <p:nvPr/>
        </p:nvSpPr>
        <p:spPr>
          <a:xfrm>
            <a:off x="175415" y="7092925"/>
            <a:ext cx="50129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Basic clinical information of three sub-clustered patients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74D88821-FB40-4A0F-9E43-E2B62FB99F9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88934" y="3741210"/>
            <a:ext cx="3240000" cy="3240000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F4F4B536-A30D-470F-B522-5C03E57FA7EC}"/>
              </a:ext>
            </a:extLst>
          </p:cNvPr>
          <p:cNvSpPr txBox="1"/>
          <p:nvPr/>
        </p:nvSpPr>
        <p:spPr>
          <a:xfrm>
            <a:off x="259702" y="619695"/>
            <a:ext cx="659829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ll HCC samples were analyzed using the R package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ConsensusClusterPlus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based on 22 apoptosis marker genes, and 3 sub-groups obtained. The basic clinical information of three sub-clustered patients is shown in the table.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7661951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FA898C01-0CC6-4E8E-81D7-74AFD8075C08}"/>
              </a:ext>
            </a:extLst>
          </p:cNvPr>
          <p:cNvSpPr txBox="1"/>
          <p:nvPr/>
        </p:nvSpPr>
        <p:spPr>
          <a:xfrm>
            <a:off x="450555" y="754825"/>
            <a:ext cx="196880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b="1" dirty="0">
                <a:latin typeface="Arial" panose="020B0604020202020204" pitchFamily="34" charset="0"/>
                <a:cs typeface="Arial" panose="020B0604020202020204" pitchFamily="34" charset="0"/>
              </a:rPr>
              <a:t>2C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continued.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1A98D508-6B42-481D-A626-A5989D6E70D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9400" y="3874918"/>
            <a:ext cx="4524376" cy="1800000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94019EA8-544F-4F60-80CB-343F0361B64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0555" y="6045755"/>
            <a:ext cx="2326921" cy="288000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B25CB718-7C69-4473-A1B4-259DBB7D81C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9400" y="1639644"/>
            <a:ext cx="3490332" cy="2160000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C6A49A95-6989-4A52-826C-91D79D0B6A5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5056" y="6045755"/>
            <a:ext cx="3332389" cy="2880000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56D35DE1-EB90-4AF5-BE6C-EB1F471E895F}"/>
              </a:ext>
            </a:extLst>
          </p:cNvPr>
          <p:cNvSpPr txBox="1"/>
          <p:nvPr/>
        </p:nvSpPr>
        <p:spPr>
          <a:xfrm>
            <a:off x="4239491" y="1560945"/>
            <a:ext cx="2618509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omparison of checkpoint molecule expression among sub-groups.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1F57F9B5-EF19-4FBC-B09D-0219BB86B30F}"/>
              </a:ext>
            </a:extLst>
          </p:cNvPr>
          <p:cNvSpPr txBox="1"/>
          <p:nvPr/>
        </p:nvSpPr>
        <p:spPr>
          <a:xfrm>
            <a:off x="5098191" y="3860245"/>
            <a:ext cx="175981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he CIBERSORT analysis of immune cell infiltration among sub-groups.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48ED23D1-9009-40CB-86BF-C8C0A93268A7}"/>
              </a:ext>
            </a:extLst>
          </p:cNvPr>
          <p:cNvSpPr txBox="1"/>
          <p:nvPr/>
        </p:nvSpPr>
        <p:spPr>
          <a:xfrm>
            <a:off x="364555" y="8951893"/>
            <a:ext cx="255413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he difference of three sub-groups responds to immune checkpoint blockade.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7C3DBD43-1E46-43E7-A533-F26F927D1F89}"/>
              </a:ext>
            </a:extLst>
          </p:cNvPr>
          <p:cNvSpPr txBox="1"/>
          <p:nvPr/>
        </p:nvSpPr>
        <p:spPr>
          <a:xfrm>
            <a:off x="3460342" y="8951893"/>
            <a:ext cx="3332389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he comparison of overall survival among the 3 sub-groups, showing no statistical significance.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3233382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449F8D59-45A2-48A5-B53C-FC0006E4C26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9478" r="6194" b="6554"/>
          <a:stretch/>
        </p:blipFill>
        <p:spPr>
          <a:xfrm>
            <a:off x="0" y="2901000"/>
            <a:ext cx="3446692" cy="205200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35AFAA0D-876A-4FF4-95E1-F956F09BF8E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8359" r="6194" b="5651"/>
          <a:stretch/>
        </p:blipFill>
        <p:spPr>
          <a:xfrm>
            <a:off x="3492351" y="2901000"/>
            <a:ext cx="3365649" cy="205200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005B1C7B-12FD-42AF-A4D5-0AF2368BC7C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5053428"/>
            <a:ext cx="6835367" cy="4546251"/>
          </a:xfrm>
          <a:prstGeom prst="rect">
            <a:avLst/>
          </a:prstGeom>
        </p:spPr>
      </p:pic>
      <p:sp>
        <p:nvSpPr>
          <p:cNvPr id="8" name="内容占位符 2">
            <a:extLst>
              <a:ext uri="{FF2B5EF4-FFF2-40B4-BE49-F238E27FC236}">
                <a16:creationId xmlns:a16="http://schemas.microsoft.com/office/drawing/2014/main" id="{A66F7105-27AD-4EDD-8AAE-A2FC20EAE77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61819" y="1358276"/>
            <a:ext cx="6179126" cy="1274087"/>
          </a:xfrm>
        </p:spPr>
        <p:txBody>
          <a:bodyPr>
            <a:normAutofit/>
          </a:bodyPr>
          <a:lstStyle/>
          <a:p>
            <a:pPr marL="0" indent="0">
              <a:lnSpc>
                <a:spcPct val="100000"/>
              </a:lnSpc>
              <a:buNone/>
            </a:pPr>
            <a:r>
              <a:rPr lang="en-GB" altLang="zh-CN" sz="14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he prognostic signature model was obtained based on 7 genes with p</a:t>
            </a:r>
            <a:r>
              <a:rPr lang="zh-CN" altLang="zh-CN" sz="14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≤</a:t>
            </a:r>
            <a:r>
              <a:rPr lang="en-GB" altLang="zh-CN" sz="14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0.01 correlation with OS and the LASSO Cox regression algorithm. The obtained </a:t>
            </a:r>
            <a:r>
              <a:rPr lang="el-GR" altLang="zh-CN" sz="14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λ</a:t>
            </a:r>
            <a:r>
              <a:rPr lang="en-US" altLang="zh-CN" sz="1400" i="0" baseline="-25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min</a:t>
            </a:r>
            <a:r>
              <a:rPr lang="en-US" altLang="zh-CN" sz="1400" i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=0.0144.The obtained </a:t>
            </a:r>
            <a:r>
              <a:rPr lang="en-US" altLang="zh-CN" sz="1400" i="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Riskscore</a:t>
            </a:r>
            <a:r>
              <a:rPr lang="en-US" altLang="zh-CN" sz="1400" i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 = (0.072)*BAK1+(0.1257)*BCAP31+ (0.0895)*BCL10+(0.2596)*E2F2+(0.1424)*SNW1. The correlation between </a:t>
            </a:r>
            <a:r>
              <a:rPr lang="en-US" altLang="zh-CN" sz="1400" i="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Riskscore</a:t>
            </a:r>
            <a:r>
              <a:rPr lang="en-US" altLang="zh-CN" sz="1400" i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 and overall survival/status is shown in the middle right graph.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D505BF75-5587-41E0-A675-47A012FCA746}"/>
              </a:ext>
            </a:extLst>
          </p:cNvPr>
          <p:cNvSpPr txBox="1"/>
          <p:nvPr/>
        </p:nvSpPr>
        <p:spPr>
          <a:xfrm>
            <a:off x="370961" y="734629"/>
            <a:ext cx="67076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>
                <a:latin typeface="Arial" panose="020B0604020202020204" pitchFamily="34" charset="0"/>
                <a:cs typeface="Arial" panose="020B0604020202020204" pitchFamily="34" charset="0"/>
              </a:rPr>
              <a:t>2D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2318659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图片 8">
            <a:extLst>
              <a:ext uri="{FF2B5EF4-FFF2-40B4-BE49-F238E27FC236}">
                <a16:creationId xmlns:a16="http://schemas.microsoft.com/office/drawing/2014/main" id="{587DFD06-ED35-4771-98E8-AD13CF0907C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9005" y="2322297"/>
            <a:ext cx="5421014" cy="4566438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215DC1DD-E10F-4ACC-BDE9-031A5ABB32B3}"/>
              </a:ext>
            </a:extLst>
          </p:cNvPr>
          <p:cNvSpPr txBox="1"/>
          <p:nvPr/>
        </p:nvSpPr>
        <p:spPr>
          <a:xfrm>
            <a:off x="702477" y="215569"/>
            <a:ext cx="559562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800" b="1" dirty="0">
                <a:latin typeface="Arial" panose="020B0604020202020204" pitchFamily="34" charset="0"/>
                <a:cs typeface="Arial" panose="020B0604020202020204" pitchFamily="34" charset="0"/>
              </a:rPr>
              <a:t>Extended Data for Figure 3</a:t>
            </a:r>
            <a:endParaRPr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613BD689-77D3-4955-9362-48B9158888ED}"/>
              </a:ext>
            </a:extLst>
          </p:cNvPr>
          <p:cNvSpPr txBox="1"/>
          <p:nvPr/>
        </p:nvSpPr>
        <p:spPr>
          <a:xfrm>
            <a:off x="484094" y="1768343"/>
            <a:ext cx="57900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3A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23C3C486-55AC-40D0-BA35-89071119DDE5}"/>
              </a:ext>
            </a:extLst>
          </p:cNvPr>
          <p:cNvSpPr txBox="1"/>
          <p:nvPr/>
        </p:nvSpPr>
        <p:spPr>
          <a:xfrm>
            <a:off x="579005" y="7073313"/>
            <a:ext cx="537103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The multi-gene correlation heatmap  of ferroptosis marker genes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96292763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4321A702-4CE1-4472-B607-91DFD730490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325328"/>
            <a:ext cx="3600000" cy="360000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ADA7765E-B9A5-4C68-8406-ECC5680DCA6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000" y="2325328"/>
            <a:ext cx="3600000" cy="360000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55012725-6867-4BE8-8B2D-B301B641650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925328"/>
            <a:ext cx="3600000" cy="3600000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21CA5C81-28DB-4357-87A9-99F8B8607A02}"/>
              </a:ext>
            </a:extLst>
          </p:cNvPr>
          <p:cNvSpPr txBox="1"/>
          <p:nvPr/>
        </p:nvSpPr>
        <p:spPr>
          <a:xfrm>
            <a:off x="528725" y="958499"/>
            <a:ext cx="57900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3B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E7E1B128-354A-4FFA-8264-A6C44FAE6C16}"/>
              </a:ext>
            </a:extLst>
          </p:cNvPr>
          <p:cNvSpPr txBox="1"/>
          <p:nvPr/>
        </p:nvSpPr>
        <p:spPr>
          <a:xfrm>
            <a:off x="528725" y="1420164"/>
            <a:ext cx="6010620" cy="6987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dditional survival curves of ferroptosis marker genes FANCD2, HSPB1 and SAT1. 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0708454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图片 10">
            <a:extLst>
              <a:ext uri="{FF2B5EF4-FFF2-40B4-BE49-F238E27FC236}">
                <a16:creationId xmlns:a16="http://schemas.microsoft.com/office/drawing/2014/main" id="{827E5343-75F2-4B73-83BE-39598337B14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3330"/>
          <a:stretch/>
        </p:blipFill>
        <p:spPr>
          <a:xfrm>
            <a:off x="4284663" y="1646499"/>
            <a:ext cx="2324460" cy="2011467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7E46A25E-284F-46BD-8638-0A294DF1A34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2559" y="1579902"/>
            <a:ext cx="4320000" cy="2160000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12B2C5C6-FEC7-486A-9389-9F6E44687A01}"/>
              </a:ext>
            </a:extLst>
          </p:cNvPr>
          <p:cNvSpPr txBox="1"/>
          <p:nvPr/>
        </p:nvSpPr>
        <p:spPr>
          <a:xfrm>
            <a:off x="192415" y="202730"/>
            <a:ext cx="57900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3C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E943C249-7866-41D0-BDB0-55AA305B207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815" y="3809635"/>
            <a:ext cx="3600184" cy="3240000"/>
          </a:xfrm>
          <a:prstGeom prst="rect">
            <a:avLst/>
          </a:prstGeom>
        </p:spPr>
      </p:pic>
      <p:graphicFrame>
        <p:nvGraphicFramePr>
          <p:cNvPr id="2" name="表格 1">
            <a:extLst>
              <a:ext uri="{FF2B5EF4-FFF2-40B4-BE49-F238E27FC236}">
                <a16:creationId xmlns:a16="http://schemas.microsoft.com/office/drawing/2014/main" id="{F5CC402B-5B73-498E-A9BF-A35962AE3E8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23079826"/>
              </p:ext>
            </p:extLst>
          </p:nvPr>
        </p:nvGraphicFramePr>
        <p:xfrm>
          <a:off x="302559" y="7493470"/>
          <a:ext cx="6252881" cy="2209800"/>
        </p:xfrm>
        <a:graphic>
          <a:graphicData uri="http://schemas.openxmlformats.org/drawingml/2006/table">
            <a:tbl>
              <a:tblPr/>
              <a:tblGrid>
                <a:gridCol w="1116965">
                  <a:extLst>
                    <a:ext uri="{9D8B030D-6E8A-4147-A177-3AD203B41FA5}">
                      <a16:colId xmlns:a16="http://schemas.microsoft.com/office/drawing/2014/main" val="1718532146"/>
                    </a:ext>
                  </a:extLst>
                </a:gridCol>
                <a:gridCol w="1553528">
                  <a:extLst>
                    <a:ext uri="{9D8B030D-6E8A-4147-A177-3AD203B41FA5}">
                      <a16:colId xmlns:a16="http://schemas.microsoft.com/office/drawing/2014/main" val="2956649964"/>
                    </a:ext>
                  </a:extLst>
                </a:gridCol>
                <a:gridCol w="895597">
                  <a:extLst>
                    <a:ext uri="{9D8B030D-6E8A-4147-A177-3AD203B41FA5}">
                      <a16:colId xmlns:a16="http://schemas.microsoft.com/office/drawing/2014/main" val="147853008"/>
                    </a:ext>
                  </a:extLst>
                </a:gridCol>
                <a:gridCol w="895597">
                  <a:extLst>
                    <a:ext uri="{9D8B030D-6E8A-4147-A177-3AD203B41FA5}">
                      <a16:colId xmlns:a16="http://schemas.microsoft.com/office/drawing/2014/main" val="572710108"/>
                    </a:ext>
                  </a:extLst>
                </a:gridCol>
                <a:gridCol w="895597">
                  <a:extLst>
                    <a:ext uri="{9D8B030D-6E8A-4147-A177-3AD203B41FA5}">
                      <a16:colId xmlns:a16="http://schemas.microsoft.com/office/drawing/2014/main" val="1887394080"/>
                    </a:ext>
                  </a:extLst>
                </a:gridCol>
                <a:gridCol w="895597">
                  <a:extLst>
                    <a:ext uri="{9D8B030D-6E8A-4147-A177-3AD203B41FA5}">
                      <a16:colId xmlns:a16="http://schemas.microsoft.com/office/drawing/2014/main" val="3854253511"/>
                    </a:ext>
                  </a:extLst>
                </a:gridCol>
              </a:tblGrid>
              <a:tr h="175260"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Describe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1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2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3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4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18375208"/>
                  </a:ext>
                </a:extLst>
              </a:tr>
              <a:tr h="17526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Status</a:t>
                      </a:r>
                    </a:p>
                  </a:txBody>
                  <a:tcPr marL="7620" marR="7620" marT="762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live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10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78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0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90495552"/>
                  </a:ext>
                </a:extLst>
              </a:tr>
              <a:tr h="175260">
                <a:tc vMerge="1">
                  <a:txBody>
                    <a:bodyPr/>
                    <a:lstStyle/>
                    <a:p>
                      <a:pPr algn="l" fontAlgn="ctr"/>
                      <a:endParaRPr lang="zh-CN" alt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Dead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6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44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61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9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7697397"/>
                  </a:ext>
                </a:extLst>
              </a:tr>
              <a:tr h="17526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ge</a:t>
                      </a:r>
                    </a:p>
                  </a:txBody>
                  <a:tcPr marL="7620" marR="7620" marT="762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Mean (SD)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56.9 (13.3)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61.6 (13.3)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57.4 (13.6)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60.8 (13.1)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385397513"/>
                  </a:ext>
                </a:extLst>
              </a:tr>
              <a:tr h="175260">
                <a:tc vMerge="1">
                  <a:txBody>
                    <a:bodyPr/>
                    <a:lstStyle/>
                    <a:p>
                      <a:pPr algn="l" fontAlgn="ctr"/>
                      <a:endParaRPr lang="zh-CN" alt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Median [MIN,MAX]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58 [24,80]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64 [17,90]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59 [18,85]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64 [16,83]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574537618"/>
                  </a:ext>
                </a:extLst>
              </a:tr>
              <a:tr h="17526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ender</a:t>
                      </a:r>
                    </a:p>
                  </a:txBody>
                  <a:tcPr marL="7620" marR="7620" marT="762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FEMALE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3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50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50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8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25443494"/>
                  </a:ext>
                </a:extLst>
              </a:tr>
              <a:tr h="175260">
                <a:tc vMerge="1">
                  <a:txBody>
                    <a:bodyPr/>
                    <a:lstStyle/>
                    <a:p>
                      <a:pPr algn="l" fontAlgn="ctr"/>
                      <a:endParaRPr lang="zh-CN" alt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MALE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6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04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89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1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34411906"/>
                  </a:ext>
                </a:extLst>
              </a:tr>
              <a:tr h="175260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TNM_stage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I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9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93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44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5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03665682"/>
                  </a:ext>
                </a:extLst>
              </a:tr>
              <a:tr h="175260">
                <a:tc vMerge="1">
                  <a:txBody>
                    <a:bodyPr/>
                    <a:lstStyle/>
                    <a:p>
                      <a:pPr algn="l" fontAlgn="ctr"/>
                      <a:endParaRPr lang="zh-CN" alt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II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3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4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8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25451359"/>
                  </a:ext>
                </a:extLst>
              </a:tr>
              <a:tr h="175260">
                <a:tc vMerge="1">
                  <a:txBody>
                    <a:bodyPr/>
                    <a:lstStyle/>
                    <a:p>
                      <a:pPr algn="l" fontAlgn="ctr"/>
                      <a:endParaRPr lang="zh-CN" alt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III-IV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48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48960142"/>
                  </a:ext>
                </a:extLst>
              </a:tr>
            </a:tbl>
          </a:graphicData>
        </a:graphic>
      </p:graphicFrame>
      <p:sp>
        <p:nvSpPr>
          <p:cNvPr id="9" name="文本框 8">
            <a:extLst>
              <a:ext uri="{FF2B5EF4-FFF2-40B4-BE49-F238E27FC236}">
                <a16:creationId xmlns:a16="http://schemas.microsoft.com/office/drawing/2014/main" id="{45617520-AB20-493A-8F92-E23031768935}"/>
              </a:ext>
            </a:extLst>
          </p:cNvPr>
          <p:cNvSpPr txBox="1"/>
          <p:nvPr/>
        </p:nvSpPr>
        <p:spPr>
          <a:xfrm>
            <a:off x="219616" y="7188005"/>
            <a:ext cx="46746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Basic clinical information of 4 sub-clustered patients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F8DCB2ED-769B-40F7-AC34-596AD2A2E40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00999" y="3892634"/>
            <a:ext cx="3157001" cy="3157001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5A24E982-CEA4-4A91-ACD6-C2D47D5C125E}"/>
              </a:ext>
            </a:extLst>
          </p:cNvPr>
          <p:cNvSpPr txBox="1"/>
          <p:nvPr/>
        </p:nvSpPr>
        <p:spPr>
          <a:xfrm>
            <a:off x="259702" y="709030"/>
            <a:ext cx="659829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HCC samples were sub-clustered into 4 groups based on ferroptosis marker genes. The basic clinical information of three sub-clustered patients is shown in the table.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510269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358</TotalTime>
  <Words>1404</Words>
  <Application>Microsoft Office PowerPoint</Application>
  <PresentationFormat>A4 纸张(210x297 毫米)</PresentationFormat>
  <Paragraphs>460</Paragraphs>
  <Slides>24</Slides>
  <Notes>2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4</vt:i4>
      </vt:variant>
    </vt:vector>
  </HeadingPairs>
  <TitlesOfParts>
    <vt:vector size="31" baseType="lpstr">
      <vt:lpstr>等线</vt:lpstr>
      <vt:lpstr>Microsoft YaHei</vt:lpstr>
      <vt:lpstr>Arial</vt:lpstr>
      <vt:lpstr>Calibri</vt:lpstr>
      <vt:lpstr>Calibri Light</vt:lpstr>
      <vt:lpstr>Roboto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optosis</dc:title>
  <dc:creator>Derei Wu</dc:creator>
  <cp:lastModifiedBy>Derei Wu</cp:lastModifiedBy>
  <cp:revision>131</cp:revision>
  <dcterms:created xsi:type="dcterms:W3CDTF">2021-11-12T03:48:01Z</dcterms:created>
  <dcterms:modified xsi:type="dcterms:W3CDTF">2021-12-30T09:06:49Z</dcterms:modified>
</cp:coreProperties>
</file>